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4"/>
  </p:notesMasterIdLst>
  <p:sldIdLst>
    <p:sldId id="258" r:id="rId2"/>
    <p:sldId id="5971" r:id="rId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596"/>
    <p:restoredTop sz="94694"/>
  </p:normalViewPr>
  <p:slideViewPr>
    <p:cSldViewPr snapToGrid="0">
      <p:cViewPr varScale="1">
        <p:scale>
          <a:sx n="91" d="100"/>
          <a:sy n="91" d="100"/>
        </p:scale>
        <p:origin x="343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B0D8923-5C29-A040-BCF4-136B17F3305A}" type="datetimeFigureOut">
              <a:rPr lang="en-US" smtClean="0"/>
              <a:t>1/21/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B1563E1-3F1D-E64E-9CAD-2CF8F37E3708}" type="slidenum">
              <a:rPr lang="en-US" smtClean="0"/>
              <a:t>‹#›</a:t>
            </a:fld>
            <a:endParaRPr lang="en-US"/>
          </a:p>
        </p:txBody>
      </p:sp>
    </p:spTree>
    <p:extLst>
      <p:ext uri="{BB962C8B-B14F-4D97-AF65-F5344CB8AC3E}">
        <p14:creationId xmlns:p14="http://schemas.microsoft.com/office/powerpoint/2010/main" val="19635697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770016"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1E0831B8-45F1-A34F-843C-4C3E578001B9}" type="slidenum">
              <a:rPr lang="en-US" smtClean="0"/>
              <a:t>1</a:t>
            </a:fld>
            <a:endParaRPr lang="en-US" dirty="0"/>
          </a:p>
        </p:txBody>
      </p:sp>
    </p:spTree>
    <p:extLst>
      <p:ext uri="{BB962C8B-B14F-4D97-AF65-F5344CB8AC3E}">
        <p14:creationId xmlns:p14="http://schemas.microsoft.com/office/powerpoint/2010/main" val="364325598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BE3D2CB-36E4-CC4C-8389-D626B50AD18A}" type="slidenum">
              <a:rPr lang="en-US" smtClean="0"/>
              <a:t>2</a:t>
            </a:fld>
            <a:endParaRPr lang="en-US"/>
          </a:p>
        </p:txBody>
      </p:sp>
    </p:spTree>
    <p:extLst>
      <p:ext uri="{BB962C8B-B14F-4D97-AF65-F5344CB8AC3E}">
        <p14:creationId xmlns:p14="http://schemas.microsoft.com/office/powerpoint/2010/main" val="5931210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8672931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32891507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957411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7030163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4EE51A4-5CD0-874C-99AC-F783733B957E}" type="datetimeFigureOut">
              <a:rPr lang="en-US" smtClean="0"/>
              <a:t>1/2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4653425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4EE51A4-5CD0-874C-99AC-F783733B957E}" type="datetimeFigureOut">
              <a:rPr lang="en-US" smtClean="0"/>
              <a:t>1/2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9611415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4EE51A4-5CD0-874C-99AC-F783733B957E}" type="datetimeFigureOut">
              <a:rPr lang="en-US" smtClean="0"/>
              <a:t>1/21/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7231831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4EE51A4-5CD0-874C-99AC-F783733B957E}" type="datetimeFigureOut">
              <a:rPr lang="en-US" smtClean="0"/>
              <a:t>1/21/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7380578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EE51A4-5CD0-874C-99AC-F783733B957E}" type="datetimeFigureOut">
              <a:rPr lang="en-US" smtClean="0"/>
              <a:t>1/21/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2290950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4EE51A4-5CD0-874C-99AC-F783733B957E}" type="datetimeFigureOut">
              <a:rPr lang="en-US" smtClean="0"/>
              <a:t>1/2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18047035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4EE51A4-5CD0-874C-99AC-F783733B957E}" type="datetimeFigureOut">
              <a:rPr lang="en-US" smtClean="0"/>
              <a:t>1/2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649317A-20A4-A641-8123-AC75D9543818}" type="slidenum">
              <a:rPr lang="en-US" smtClean="0"/>
              <a:t>‹#›</a:t>
            </a:fld>
            <a:endParaRPr lang="en-US"/>
          </a:p>
        </p:txBody>
      </p:sp>
    </p:spTree>
    <p:extLst>
      <p:ext uri="{BB962C8B-B14F-4D97-AF65-F5344CB8AC3E}">
        <p14:creationId xmlns:p14="http://schemas.microsoft.com/office/powerpoint/2010/main" val="20069406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B4EE51A4-5CD0-874C-99AC-F783733B957E}" type="datetimeFigureOut">
              <a:rPr lang="en-US" smtClean="0"/>
              <a:t>1/21/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649317A-20A4-A641-8123-AC75D9543818}" type="slidenum">
              <a:rPr lang="en-US" smtClean="0"/>
              <a:t>‹#›</a:t>
            </a:fld>
            <a:endParaRPr lang="en-US"/>
          </a:p>
        </p:txBody>
      </p:sp>
    </p:spTree>
    <p:extLst>
      <p:ext uri="{BB962C8B-B14F-4D97-AF65-F5344CB8AC3E}">
        <p14:creationId xmlns:p14="http://schemas.microsoft.com/office/powerpoint/2010/main" val="178093913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8.png"/><Relationship Id="rId18" Type="http://schemas.openxmlformats.org/officeDocument/2006/relationships/image" Target="../media/image13.emf"/><Relationship Id="rId3" Type="http://schemas.openxmlformats.org/officeDocument/2006/relationships/image" Target="../media/image1.png"/><Relationship Id="rId7" Type="http://schemas.openxmlformats.org/officeDocument/2006/relationships/image" Target="../media/image3.png"/><Relationship Id="rId12" Type="http://schemas.openxmlformats.org/officeDocument/2006/relationships/image" Target="../media/image7.png"/><Relationship Id="rId17" Type="http://schemas.openxmlformats.org/officeDocument/2006/relationships/image" Target="../media/image12.png"/><Relationship Id="rId2" Type="http://schemas.openxmlformats.org/officeDocument/2006/relationships/notesSlide" Target="../notesSlides/notesSlide1.xml"/><Relationship Id="rId16" Type="http://schemas.openxmlformats.org/officeDocument/2006/relationships/image" Target="../media/image11.png"/><Relationship Id="rId1" Type="http://schemas.openxmlformats.org/officeDocument/2006/relationships/slideLayout" Target="../slideLayouts/slideLayout1.xml"/><Relationship Id="rId6" Type="http://schemas.microsoft.com/office/2007/relationships/hdphoto" Target="../media/hdphoto2.wdp"/><Relationship Id="rId11" Type="http://schemas.openxmlformats.org/officeDocument/2006/relationships/image" Target="../media/image6.png"/><Relationship Id="rId5" Type="http://schemas.openxmlformats.org/officeDocument/2006/relationships/image" Target="../media/image2.png"/><Relationship Id="rId15" Type="http://schemas.openxmlformats.org/officeDocument/2006/relationships/image" Target="../media/image10.png"/><Relationship Id="rId10" Type="http://schemas.openxmlformats.org/officeDocument/2006/relationships/image" Target="../media/image5.png"/><Relationship Id="rId19" Type="http://schemas.openxmlformats.org/officeDocument/2006/relationships/image" Target="../media/image14.emf"/><Relationship Id="rId4" Type="http://schemas.microsoft.com/office/2007/relationships/hdphoto" Target="../media/hdphoto1.wdp"/><Relationship Id="rId9" Type="http://schemas.openxmlformats.org/officeDocument/2006/relationships/image" Target="../media/image4.png"/><Relationship Id="rId14" Type="http://schemas.openxmlformats.org/officeDocument/2006/relationships/image" Target="../media/image9.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AC4EFBD-DEEB-428D-AEC0-E1F0BEB125F1}"/>
              </a:ext>
            </a:extLst>
          </p:cNvPr>
          <p:cNvPicPr>
            <a:picLocks noChangeAspect="1"/>
          </p:cNvPicPr>
          <p:nvPr/>
        </p:nvPicPr>
        <p:blipFill rotWithShape="1">
          <a:blip r:embed="rId3">
            <a:extLst>
              <a:ext uri="{BEBA8EAE-BF5A-486C-A8C5-ECC9F3942E4B}">
                <a14:imgProps xmlns:a14="http://schemas.microsoft.com/office/drawing/2010/main">
                  <a14:imgLayer r:embed="rId4">
                    <a14:imgEffect>
                      <a14:backgroundRemoval t="17717" b="75197" l="24678" r="75046">
                        <a14:foregroundMark x1="29926" y1="22835" x2="27532" y2="18307"/>
                        <a14:foregroundMark x1="24954" y1="18110" x2="24678" y2="55709"/>
                        <a14:foregroundMark x1="34530" y1="73031" x2="40239" y2="75197"/>
                        <a14:foregroundMark x1="72560" y1="71260" x2="73112" y2="70669"/>
                        <a14:foregroundMark x1="74862" y1="56496" x2="75046" y2="61614"/>
                      </a14:backgroundRemoval>
                    </a14:imgEffect>
                  </a14:imgLayer>
                </a14:imgProps>
              </a:ext>
            </a:extLst>
          </a:blip>
          <a:srcRect l="22735" t="13693" r="23698" b="19113"/>
          <a:stretch/>
        </p:blipFill>
        <p:spPr>
          <a:xfrm rot="21411168">
            <a:off x="582459" y="1050238"/>
            <a:ext cx="1509579" cy="745930"/>
          </a:xfrm>
          <a:prstGeom prst="rect">
            <a:avLst/>
          </a:prstGeom>
        </p:spPr>
      </p:pic>
      <p:pic>
        <p:nvPicPr>
          <p:cNvPr id="120" name="Picture 119">
            <a:extLst>
              <a:ext uri="{FF2B5EF4-FFF2-40B4-BE49-F238E27FC236}">
                <a16:creationId xmlns:a16="http://schemas.microsoft.com/office/drawing/2014/main" id="{A88DD223-0691-4690-A9D7-2AE48A60523E}"/>
              </a:ext>
            </a:extLst>
          </p:cNvPr>
          <p:cNvPicPr>
            <a:picLocks noChangeAspect="1"/>
          </p:cNvPicPr>
          <p:nvPr/>
        </p:nvPicPr>
        <p:blipFill rotWithShape="1">
          <a:blip r:embed="rId5">
            <a:extLst>
              <a:ext uri="{BEBA8EAE-BF5A-486C-A8C5-ECC9F3942E4B}">
                <a14:imgProps xmlns:a14="http://schemas.microsoft.com/office/drawing/2010/main">
                  <a14:imgLayer r:embed="rId6">
                    <a14:imgEffect>
                      <a14:backgroundRemoval t="53135" b="94719" l="52400" r="94900">
                        <a14:foregroundMark x1="53300" y1="78218" x2="52400" y2="53795"/>
                      </a14:backgroundRemoval>
                    </a14:imgEffect>
                  </a14:imgLayer>
                </a14:imgProps>
              </a:ext>
            </a:extLst>
          </a:blip>
          <a:srcRect l="49442" t="47957"/>
          <a:stretch/>
        </p:blipFill>
        <p:spPr>
          <a:xfrm>
            <a:off x="3372750" y="1031494"/>
            <a:ext cx="2036553" cy="1101942"/>
          </a:xfrm>
          <a:prstGeom prst="rect">
            <a:avLst/>
          </a:prstGeom>
        </p:spPr>
      </p:pic>
      <p:sp>
        <p:nvSpPr>
          <p:cNvPr id="90" name="Rectangle 89">
            <a:extLst>
              <a:ext uri="{FF2B5EF4-FFF2-40B4-BE49-F238E27FC236}">
                <a16:creationId xmlns:a16="http://schemas.microsoft.com/office/drawing/2014/main" id="{9D360079-CD71-44C5-BB5C-DF695702ECBA}"/>
              </a:ext>
            </a:extLst>
          </p:cNvPr>
          <p:cNvSpPr/>
          <p:nvPr/>
        </p:nvSpPr>
        <p:spPr>
          <a:xfrm>
            <a:off x="467953" y="703808"/>
            <a:ext cx="3384281" cy="356123"/>
          </a:xfrm>
          <a:prstGeom prst="rect">
            <a:avLst/>
          </a:prstGeom>
        </p:spPr>
        <p:txBody>
          <a:bodyPr wrap="square">
            <a:spAutoFit/>
          </a:bodyPr>
          <a:lstStyle/>
          <a:p>
            <a:r>
              <a:rPr lang="en-US" sz="857" b="1" dirty="0">
                <a:latin typeface="Arial" panose="020B0604020202020204" pitchFamily="34" charset="0"/>
                <a:cs typeface="Arial" panose="020B0604020202020204" pitchFamily="34" charset="0"/>
              </a:rPr>
              <a:t>Bone Marker 900.40 m/z</a:t>
            </a:r>
          </a:p>
          <a:p>
            <a:r>
              <a:rPr lang="en-US" sz="857" dirty="0">
                <a:latin typeface="Arial" panose="020B0604020202020204" pitchFamily="34" charset="0"/>
                <a:cs typeface="Arial" panose="020B0604020202020204" pitchFamily="34" charset="0"/>
              </a:rPr>
              <a:t>COL1A1 - GPAGERGEQ</a:t>
            </a:r>
            <a:r>
              <a:rPr lang="nl-NL" sz="857" dirty="0">
                <a:latin typeface="Arial" panose="020B0604020202020204" pitchFamily="34" charset="0"/>
                <a:cs typeface="Arial" panose="020B0604020202020204" pitchFamily="34" charset="0"/>
              </a:rPr>
              <a:t> </a:t>
            </a:r>
          </a:p>
        </p:txBody>
      </p:sp>
      <p:sp>
        <p:nvSpPr>
          <p:cNvPr id="97" name="Rectangle 96">
            <a:extLst>
              <a:ext uri="{FF2B5EF4-FFF2-40B4-BE49-F238E27FC236}">
                <a16:creationId xmlns:a16="http://schemas.microsoft.com/office/drawing/2014/main" id="{77BDF9C4-7D51-4534-8438-A1EDA407FCF2}"/>
              </a:ext>
            </a:extLst>
          </p:cNvPr>
          <p:cNvSpPr/>
          <p:nvPr/>
        </p:nvSpPr>
        <p:spPr>
          <a:xfrm>
            <a:off x="3358078" y="687529"/>
            <a:ext cx="3384281" cy="356123"/>
          </a:xfrm>
          <a:prstGeom prst="rect">
            <a:avLst/>
          </a:prstGeom>
        </p:spPr>
        <p:txBody>
          <a:bodyPr wrap="square">
            <a:spAutoFit/>
          </a:bodyPr>
          <a:lstStyle/>
          <a:p>
            <a:r>
              <a:rPr lang="en-US" sz="857" b="1" dirty="0">
                <a:latin typeface="Arial" panose="020B0604020202020204" pitchFamily="34" charset="0"/>
                <a:cs typeface="Arial" panose="020B0604020202020204" pitchFamily="34" charset="0"/>
              </a:rPr>
              <a:t>Cartilage Marker 1097.53 m/z</a:t>
            </a:r>
          </a:p>
          <a:p>
            <a:r>
              <a:rPr lang="en-US" sz="857" dirty="0">
                <a:latin typeface="Arial" panose="020B0604020202020204" pitchFamily="34" charset="0"/>
                <a:cs typeface="Arial" panose="020B0604020202020204" pitchFamily="34" charset="0"/>
              </a:rPr>
              <a:t>COL2A1 - </a:t>
            </a:r>
            <a:r>
              <a:rPr lang="en-US" sz="857" dirty="0">
                <a:solidFill>
                  <a:srgbClr val="000000"/>
                </a:solidFill>
                <a:latin typeface="Arial" panose="020B0604020202020204" pitchFamily="34" charset="0"/>
                <a:cs typeface="Arial" panose="020B0604020202020204" pitchFamily="34" charset="0"/>
              </a:rPr>
              <a:t>GPSGEPGKQGAP</a:t>
            </a:r>
            <a:endParaRPr lang="nl-NL" sz="857" dirty="0">
              <a:latin typeface="Arial" panose="020B0604020202020204" pitchFamily="34" charset="0"/>
              <a:cs typeface="Arial" panose="020B0604020202020204" pitchFamily="34" charset="0"/>
            </a:endParaRPr>
          </a:p>
        </p:txBody>
      </p:sp>
      <p:grpSp>
        <p:nvGrpSpPr>
          <p:cNvPr id="23" name="Group 22">
            <a:extLst>
              <a:ext uri="{FF2B5EF4-FFF2-40B4-BE49-F238E27FC236}">
                <a16:creationId xmlns:a16="http://schemas.microsoft.com/office/drawing/2014/main" id="{31BF0834-8EFA-4FDB-AF4F-433908712BB4}"/>
              </a:ext>
            </a:extLst>
          </p:cNvPr>
          <p:cNvGrpSpPr/>
          <p:nvPr/>
        </p:nvGrpSpPr>
        <p:grpSpPr>
          <a:xfrm>
            <a:off x="496467" y="1993427"/>
            <a:ext cx="569656" cy="265457"/>
            <a:chOff x="361884" y="6977229"/>
            <a:chExt cx="593858" cy="319040"/>
          </a:xfrm>
        </p:grpSpPr>
        <p:grpSp>
          <p:nvGrpSpPr>
            <p:cNvPr id="21" name="Group 20">
              <a:extLst>
                <a:ext uri="{FF2B5EF4-FFF2-40B4-BE49-F238E27FC236}">
                  <a16:creationId xmlns:a16="http://schemas.microsoft.com/office/drawing/2014/main" id="{8C31BB2D-3904-462C-B607-D38846465D9F}"/>
                </a:ext>
              </a:extLst>
            </p:cNvPr>
            <p:cNvGrpSpPr/>
            <p:nvPr/>
          </p:nvGrpSpPr>
          <p:grpSpPr>
            <a:xfrm>
              <a:off x="416356" y="7202058"/>
              <a:ext cx="427648" cy="75910"/>
              <a:chOff x="409784" y="7202058"/>
              <a:chExt cx="427648" cy="75910"/>
            </a:xfrm>
          </p:grpSpPr>
          <p:cxnSp>
            <p:nvCxnSpPr>
              <p:cNvPr id="8" name="Straight Connector 7">
                <a:extLst>
                  <a:ext uri="{FF2B5EF4-FFF2-40B4-BE49-F238E27FC236}">
                    <a16:creationId xmlns:a16="http://schemas.microsoft.com/office/drawing/2014/main" id="{1937015D-EF21-49CF-BA51-EFEB7B2EBB66}"/>
                  </a:ext>
                </a:extLst>
              </p:cNvPr>
              <p:cNvCxnSpPr>
                <a:cxnSpLocks/>
              </p:cNvCxnSpPr>
              <p:nvPr/>
            </p:nvCxnSpPr>
            <p:spPr>
              <a:xfrm>
                <a:off x="409784" y="7240013"/>
                <a:ext cx="42764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Straight Connector 120">
                <a:extLst>
                  <a:ext uri="{FF2B5EF4-FFF2-40B4-BE49-F238E27FC236}">
                    <a16:creationId xmlns:a16="http://schemas.microsoft.com/office/drawing/2014/main" id="{E50B42C3-DC8A-46D2-896B-7FBC8264DE7B}"/>
                  </a:ext>
                </a:extLst>
              </p:cNvPr>
              <p:cNvCxnSpPr>
                <a:cxnSpLocks/>
              </p:cNvCxnSpPr>
              <p:nvPr/>
            </p:nvCxnSpPr>
            <p:spPr>
              <a:xfrm flipV="1">
                <a:off x="409784" y="7202058"/>
                <a:ext cx="0" cy="7591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a:extLst>
                  <a:ext uri="{FF2B5EF4-FFF2-40B4-BE49-F238E27FC236}">
                    <a16:creationId xmlns:a16="http://schemas.microsoft.com/office/drawing/2014/main" id="{97878D67-B416-410E-8899-DE1273D1F2A8}"/>
                  </a:ext>
                </a:extLst>
              </p:cNvPr>
              <p:cNvCxnSpPr>
                <a:cxnSpLocks/>
              </p:cNvCxnSpPr>
              <p:nvPr/>
            </p:nvCxnSpPr>
            <p:spPr>
              <a:xfrm flipV="1">
                <a:off x="837432" y="7202058"/>
                <a:ext cx="0" cy="7591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2" name="TextBox 21">
              <a:extLst>
                <a:ext uri="{FF2B5EF4-FFF2-40B4-BE49-F238E27FC236}">
                  <a16:creationId xmlns:a16="http://schemas.microsoft.com/office/drawing/2014/main" id="{0EA94A50-8FDA-4A48-8A62-9D5F61C84B72}"/>
                </a:ext>
              </a:extLst>
            </p:cNvPr>
            <p:cNvSpPr txBox="1"/>
            <p:nvPr/>
          </p:nvSpPr>
          <p:spPr>
            <a:xfrm>
              <a:off x="361884" y="6977229"/>
              <a:ext cx="593858" cy="319040"/>
            </a:xfrm>
            <a:prstGeom prst="rect">
              <a:avLst/>
            </a:prstGeom>
            <a:noFill/>
          </p:spPr>
          <p:txBody>
            <a:bodyPr wrap="square" rtlCol="0">
              <a:spAutoFit/>
            </a:bodyPr>
            <a:lstStyle/>
            <a:p>
              <a:r>
                <a:rPr lang="en-US" sz="1125" b="1" dirty="0">
                  <a:latin typeface="Arial" panose="020B0604020202020204" pitchFamily="34" charset="0"/>
                  <a:cs typeface="Arial" panose="020B0604020202020204" pitchFamily="34" charset="0"/>
                </a:rPr>
                <a:t>1 cm</a:t>
              </a:r>
            </a:p>
          </p:txBody>
        </p:sp>
      </p:grpSp>
      <p:grpSp>
        <p:nvGrpSpPr>
          <p:cNvPr id="73" name="Group 72">
            <a:extLst>
              <a:ext uri="{FF2B5EF4-FFF2-40B4-BE49-F238E27FC236}">
                <a16:creationId xmlns:a16="http://schemas.microsoft.com/office/drawing/2014/main" id="{F1060930-CCED-42E7-AB31-5A0C3991AE11}"/>
              </a:ext>
            </a:extLst>
          </p:cNvPr>
          <p:cNvGrpSpPr/>
          <p:nvPr/>
        </p:nvGrpSpPr>
        <p:grpSpPr>
          <a:xfrm>
            <a:off x="590714" y="1781739"/>
            <a:ext cx="1480999" cy="323165"/>
            <a:chOff x="508891" y="6934021"/>
            <a:chExt cx="1543922" cy="388396"/>
          </a:xfrm>
        </p:grpSpPr>
        <p:pic>
          <p:nvPicPr>
            <p:cNvPr id="93" name="Picture 92">
              <a:extLst>
                <a:ext uri="{FF2B5EF4-FFF2-40B4-BE49-F238E27FC236}">
                  <a16:creationId xmlns:a16="http://schemas.microsoft.com/office/drawing/2014/main" id="{41406E2D-8787-45CC-BFAD-0E85410E7F3D}"/>
                </a:ext>
              </a:extLst>
            </p:cNvPr>
            <p:cNvPicPr>
              <a:picLocks noChangeAspect="1"/>
            </p:cNvPicPr>
            <p:nvPr/>
          </p:nvPicPr>
          <p:blipFill rotWithShape="1">
            <a:blip r:embed="rId7">
              <a:extLst>
                <a:ext uri="{BEBA8EAE-BF5A-486C-A8C5-ECC9F3942E4B}">
                  <a14:imgProps xmlns:a14="http://schemas.microsoft.com/office/drawing/2010/main">
                    <a14:imgLayer r:embed="rId8">
                      <a14:imgEffect>
                        <a14:backgroundRemoval t="87129" b="99835" l="77900" r="99800">
                          <a14:foregroundMark x1="80801" y1="90596" x2="81200" y2="91254"/>
                          <a14:foregroundMark x1="80900" y1="91089" x2="80400" y2="99175"/>
                          <a14:foregroundMark x1="80338" y1="91089" x2="79800" y2="99670"/>
                          <a14:foregroundMark x1="80359" y1="90759" x2="80338" y2="91089"/>
                          <a14:foregroundMark x1="80390" y1="90264" x2="80359" y2="90759"/>
                          <a14:foregroundMark x1="80400" y1="91749" x2="78900" y2="99670"/>
                          <a14:foregroundMark x1="79391" y1="94195" x2="77900" y2="99835"/>
                          <a14:foregroundMark x1="80213" y1="91089" x2="79412" y2="94115"/>
                          <a14:foregroundMark x1="80300" y1="90759" x2="80213" y2="91089"/>
                          <a14:foregroundMark x1="80000" y1="91254" x2="91800" y2="89274"/>
                          <a14:foregroundMark x1="91800" y1="89274" x2="94800" y2="99835"/>
                          <a14:foregroundMark x1="79800" y1="92574" x2="91200" y2="88119"/>
                          <a14:foregroundMark x1="91200" y1="88119" x2="99800" y2="88284"/>
                          <a14:foregroundMark x1="92000" y1="88614" x2="99400" y2="98185"/>
                          <a14:foregroundMark x1="97000" y1="90264" x2="99700" y2="96700"/>
                          <a14:foregroundMark x1="95800" y1="89769" x2="95800" y2="89769"/>
                          <a14:foregroundMark x1="93300" y1="90594" x2="99800" y2="92574"/>
                          <a14:foregroundMark x1="95000" y1="90594" x2="99700" y2="90759"/>
                          <a14:foregroundMark x1="94400" y1="89604" x2="99700" y2="89274"/>
                          <a14:foregroundMark x1="96900" y1="88614" x2="99700" y2="90594"/>
                          <a14:foregroundMark x1="96100" y1="89274" x2="99300" y2="90594"/>
                          <a14:foregroundMark x1="94200" y1="89604" x2="94200" y2="89604"/>
                          <a14:foregroundMark x1="94800" y1="89604" x2="94800" y2="89604"/>
                          <a14:foregroundMark x1="95000" y1="89604" x2="95000" y2="89604"/>
                          <a14:foregroundMark x1="95100" y1="89604" x2="95100" y2="89604"/>
                          <a14:foregroundMark x1="95100" y1="89604" x2="95100" y2="89604"/>
                          <a14:foregroundMark x1="95000" y1="89604" x2="95000" y2="89604"/>
                          <a14:foregroundMark x1="95000" y1="89604" x2="96100" y2="89769"/>
                          <a14:foregroundMark x1="91500" y1="88119" x2="80801" y2="87834"/>
                          <a14:foregroundMark x1="79612" y1="91089" x2="79500" y2="92739"/>
                          <a14:foregroundMark x1="79634" y1="90759" x2="79612" y2="91089"/>
                          <a14:foregroundMark x1="79667" y1="90264" x2="79634" y2="90759"/>
                          <a14:foregroundMark x1="80400" y1="98185" x2="85900" y2="97690"/>
                          <a14:foregroundMark x1="79500" y1="93564" x2="90900" y2="95875"/>
                          <a14:foregroundMark x1="90900" y1="95875" x2="99800" y2="95710"/>
                          <a14:foregroundMark x1="87200" y1="95710" x2="92000" y2="99670"/>
                          <a14:foregroundMark x1="85300" y1="95710" x2="92700" y2="97690"/>
                          <a14:foregroundMark x1="84600" y1="96865" x2="94800" y2="94719"/>
                          <a14:foregroundMark x1="85600" y1="99175" x2="99800" y2="96865"/>
                          <a14:foregroundMark x1="82800" y1="93069" x2="92600" y2="95050"/>
                          <a14:foregroundMark x1="80300" y1="97360" x2="82600" y2="97360"/>
                          <a14:foregroundMark x1="80000" y1="89604" x2="80000" y2="88284"/>
                          <a14:foregroundMark x1="79800" y1="88614" x2="80400" y2="88119"/>
                          <a14:foregroundMark x1="94200" y1="89109" x2="98800" y2="89109"/>
                          <a14:foregroundMark x1="94700" y1="89109" x2="99300" y2="89769"/>
                          <a14:foregroundMark x1="94400" y1="88284" x2="99800" y2="88614"/>
                          <a14:foregroundMark x1="96300" y1="89109" x2="99100" y2="89109"/>
                          <a14:backgroundMark x1="78900" y1="91749" x2="78500" y2="86469"/>
                          <a14:backgroundMark x1="79100" y1="87129" x2="79100" y2="90264"/>
                        </a14:backgroundRemoval>
                      </a14:imgEffect>
                    </a14:imgLayer>
                  </a14:imgProps>
                </a:ext>
              </a:extLst>
            </a:blip>
            <a:srcRect l="78380" t="85751"/>
            <a:stretch/>
          </p:blipFill>
          <p:spPr>
            <a:xfrm>
              <a:off x="1146351" y="6941337"/>
              <a:ext cx="906462" cy="362016"/>
            </a:xfrm>
            <a:prstGeom prst="rect">
              <a:avLst/>
            </a:prstGeom>
          </p:spPr>
        </p:pic>
        <p:sp>
          <p:nvSpPr>
            <p:cNvPr id="72" name="TextBox 71">
              <a:extLst>
                <a:ext uri="{FF2B5EF4-FFF2-40B4-BE49-F238E27FC236}">
                  <a16:creationId xmlns:a16="http://schemas.microsoft.com/office/drawing/2014/main" id="{9E05CE07-F4ED-42AF-BEFA-A41508F8EFE3}"/>
                </a:ext>
              </a:extLst>
            </p:cNvPr>
            <p:cNvSpPr txBox="1"/>
            <p:nvPr/>
          </p:nvSpPr>
          <p:spPr>
            <a:xfrm>
              <a:off x="508891" y="6934021"/>
              <a:ext cx="692174" cy="388396"/>
            </a:xfrm>
            <a:prstGeom prst="rect">
              <a:avLst/>
            </a:prstGeom>
            <a:noFill/>
          </p:spPr>
          <p:txBody>
            <a:bodyPr wrap="none" rtlCol="0">
              <a:spAutoFit/>
            </a:bodyPr>
            <a:lstStyle/>
            <a:p>
              <a:pPr algn="ctr"/>
              <a:r>
                <a:rPr lang="en-US" sz="750" b="1" dirty="0">
                  <a:latin typeface="Arial" panose="020B0604020202020204" pitchFamily="34" charset="0"/>
                  <a:cs typeface="Arial" panose="020B0604020202020204" pitchFamily="34" charset="0"/>
                </a:rPr>
                <a:t>900.40 m/z</a:t>
              </a:r>
            </a:p>
            <a:p>
              <a:pPr algn="ctr"/>
              <a:r>
                <a:rPr lang="en-US" sz="750" b="1" dirty="0">
                  <a:latin typeface="Arial" panose="020B0604020202020204" pitchFamily="34" charset="0"/>
                  <a:cs typeface="Arial" panose="020B0604020202020204" pitchFamily="34" charset="0"/>
                </a:rPr>
                <a:t>± 15 ppm</a:t>
              </a:r>
            </a:p>
          </p:txBody>
        </p:sp>
      </p:grpSp>
      <p:grpSp>
        <p:nvGrpSpPr>
          <p:cNvPr id="75" name="Group 74">
            <a:extLst>
              <a:ext uri="{FF2B5EF4-FFF2-40B4-BE49-F238E27FC236}">
                <a16:creationId xmlns:a16="http://schemas.microsoft.com/office/drawing/2014/main" id="{F9CA5900-27A0-48BB-AA50-B0514E36ECCB}"/>
              </a:ext>
            </a:extLst>
          </p:cNvPr>
          <p:cNvGrpSpPr/>
          <p:nvPr/>
        </p:nvGrpSpPr>
        <p:grpSpPr>
          <a:xfrm>
            <a:off x="3413453" y="1781739"/>
            <a:ext cx="1486305" cy="323165"/>
            <a:chOff x="3344363" y="6870328"/>
            <a:chExt cx="1549453" cy="388396"/>
          </a:xfrm>
        </p:grpSpPr>
        <p:pic>
          <p:nvPicPr>
            <p:cNvPr id="94" name="Picture 93">
              <a:extLst>
                <a:ext uri="{FF2B5EF4-FFF2-40B4-BE49-F238E27FC236}">
                  <a16:creationId xmlns:a16="http://schemas.microsoft.com/office/drawing/2014/main" id="{16CFCAB2-05C7-41A5-99C1-508329D4D57C}"/>
                </a:ext>
              </a:extLst>
            </p:cNvPr>
            <p:cNvPicPr>
              <a:picLocks noChangeAspect="1"/>
            </p:cNvPicPr>
            <p:nvPr/>
          </p:nvPicPr>
          <p:blipFill rotWithShape="1">
            <a:blip r:embed="rId9">
              <a:extLst>
                <a:ext uri="{BEBA8EAE-BF5A-486C-A8C5-ECC9F3942E4B}">
                  <a14:imgProps xmlns:a14="http://schemas.microsoft.com/office/drawing/2010/main">
                    <a14:imgLayer r:embed="rId6">
                      <a14:imgEffect>
                        <a14:backgroundRemoval t="87459" b="99670" l="78400" r="99900">
                          <a14:foregroundMark x1="80500" y1="89274" x2="78700" y2="99670"/>
                          <a14:foregroundMark x1="80300" y1="89934" x2="82700" y2="98845"/>
                          <a14:foregroundMark x1="79300" y1="99175" x2="89500" y2="96040"/>
                          <a14:foregroundMark x1="81500" y1="96865" x2="95300" y2="93894"/>
                          <a14:foregroundMark x1="85900" y1="97525" x2="95600" y2="99670"/>
                          <a14:foregroundMark x1="89000" y1="98350" x2="99100" y2="94059"/>
                          <a14:foregroundMark x1="80000" y1="91254" x2="95100" y2="89934"/>
                          <a14:foregroundMark x1="95100" y1="89934" x2="99700" y2="90759"/>
                          <a14:foregroundMark x1="79900" y1="88779" x2="80300" y2="91254"/>
                          <a14:foregroundMark x1="79900" y1="88449" x2="94100" y2="89439"/>
                          <a14:foregroundMark x1="81800" y1="88779" x2="99100" y2="89769"/>
                          <a14:foregroundMark x1="92000" y1="88944" x2="99900" y2="89274"/>
                          <a14:foregroundMark x1="92200" y1="88284" x2="98400" y2="87459"/>
                          <a14:foregroundMark x1="96200" y1="87954" x2="99600" y2="89439"/>
                          <a14:foregroundMark x1="97300" y1="88779" x2="99300" y2="88449"/>
                          <a14:foregroundMark x1="99000" y1="88449" x2="99900" y2="89934"/>
                          <a14:foregroundMark x1="97900" y1="89439" x2="97500" y2="94554"/>
                          <a14:foregroundMark x1="96000" y1="91749" x2="95900" y2="96865"/>
                          <a14:foregroundMark x1="96000" y1="89934" x2="91000" y2="94554"/>
                          <a14:foregroundMark x1="93300" y1="91254" x2="82400" y2="93564"/>
                          <a14:foregroundMark x1="94800" y1="93069" x2="88500" y2="97525"/>
                          <a14:foregroundMark x1="94500" y1="95545" x2="90800" y2="96370"/>
                          <a14:foregroundMark x1="94100" y1="96370" x2="97300" y2="99175"/>
                          <a14:foregroundMark x1="93200" y1="96865" x2="95000" y2="99010"/>
                          <a14:foregroundMark x1="96000" y1="96535" x2="99700" y2="98350"/>
                          <a14:foregroundMark x1="85000" y1="96040" x2="79000" y2="97360"/>
                          <a14:foregroundMark x1="83700" y1="95875" x2="79100" y2="95380"/>
                          <a14:foregroundMark x1="81000" y1="96865" x2="78500" y2="96040"/>
                          <a14:foregroundMark x1="82200" y1="97030" x2="80300" y2="97525"/>
                          <a14:foregroundMark x1="78400" y1="99175" x2="80200" y2="91419"/>
                          <a14:foregroundMark x1="80200" y1="91419" x2="78800" y2="98845"/>
                          <a14:foregroundMark x1="78700" y1="98515" x2="78400" y2="96370"/>
                          <a14:foregroundMark x1="78700" y1="96040" x2="79600" y2="92574"/>
                          <a14:foregroundMark x1="80700" y1="88284" x2="92300" y2="88284"/>
                          <a14:foregroundMark x1="92300" y1="88284" x2="92500" y2="88284"/>
                        </a14:backgroundRemoval>
                      </a14:imgEffect>
                    </a14:imgLayer>
                  </a14:imgProps>
                </a:ext>
              </a:extLst>
            </a:blip>
            <a:srcRect l="78205" t="87334"/>
            <a:stretch/>
          </p:blipFill>
          <p:spPr>
            <a:xfrm>
              <a:off x="3978573" y="6922331"/>
              <a:ext cx="915243" cy="322304"/>
            </a:xfrm>
            <a:prstGeom prst="rect">
              <a:avLst/>
            </a:prstGeom>
          </p:spPr>
        </p:pic>
        <p:sp>
          <p:nvSpPr>
            <p:cNvPr id="138" name="TextBox 137">
              <a:extLst>
                <a:ext uri="{FF2B5EF4-FFF2-40B4-BE49-F238E27FC236}">
                  <a16:creationId xmlns:a16="http://schemas.microsoft.com/office/drawing/2014/main" id="{55A031EB-0A90-4D5A-9C17-C230817855A7}"/>
                </a:ext>
              </a:extLst>
            </p:cNvPr>
            <p:cNvSpPr txBox="1"/>
            <p:nvPr/>
          </p:nvSpPr>
          <p:spPr>
            <a:xfrm>
              <a:off x="3344363" y="6870328"/>
              <a:ext cx="747320" cy="388396"/>
            </a:xfrm>
            <a:prstGeom prst="rect">
              <a:avLst/>
            </a:prstGeom>
            <a:noFill/>
          </p:spPr>
          <p:txBody>
            <a:bodyPr wrap="none" rtlCol="0">
              <a:spAutoFit/>
            </a:bodyPr>
            <a:lstStyle/>
            <a:p>
              <a:pPr algn="ctr"/>
              <a:r>
                <a:rPr lang="en-US" sz="750" b="1" dirty="0">
                  <a:latin typeface="Arial" panose="020B0604020202020204" pitchFamily="34" charset="0"/>
                  <a:cs typeface="Arial" panose="020B0604020202020204" pitchFamily="34" charset="0"/>
                </a:rPr>
                <a:t>1097.53 m/z</a:t>
              </a:r>
            </a:p>
            <a:p>
              <a:pPr algn="ctr"/>
              <a:r>
                <a:rPr lang="en-US" sz="750" b="1" dirty="0">
                  <a:latin typeface="Arial" panose="020B0604020202020204" pitchFamily="34" charset="0"/>
                  <a:cs typeface="Arial" panose="020B0604020202020204" pitchFamily="34" charset="0"/>
                </a:rPr>
                <a:t>± 15 ppm</a:t>
              </a:r>
            </a:p>
          </p:txBody>
        </p:sp>
      </p:grpSp>
      <p:sp>
        <p:nvSpPr>
          <p:cNvPr id="139" name="TextBox 138">
            <a:extLst>
              <a:ext uri="{FF2B5EF4-FFF2-40B4-BE49-F238E27FC236}">
                <a16:creationId xmlns:a16="http://schemas.microsoft.com/office/drawing/2014/main" id="{FFB2E1DE-AE11-454C-BAD1-872D2A61F2D7}"/>
              </a:ext>
            </a:extLst>
          </p:cNvPr>
          <p:cNvSpPr txBox="1"/>
          <p:nvPr/>
        </p:nvSpPr>
        <p:spPr>
          <a:xfrm>
            <a:off x="477993" y="477429"/>
            <a:ext cx="4528291" cy="290208"/>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A – Tissue Specific Markers for Skeletal Extracellular Matrix</a:t>
            </a:r>
          </a:p>
        </p:txBody>
      </p:sp>
      <p:sp>
        <p:nvSpPr>
          <p:cNvPr id="123" name="TextBox 122">
            <a:extLst>
              <a:ext uri="{FF2B5EF4-FFF2-40B4-BE49-F238E27FC236}">
                <a16:creationId xmlns:a16="http://schemas.microsoft.com/office/drawing/2014/main" id="{74035B00-89C9-4585-90E3-A883D3FB08AF}"/>
              </a:ext>
            </a:extLst>
          </p:cNvPr>
          <p:cNvSpPr txBox="1"/>
          <p:nvPr/>
        </p:nvSpPr>
        <p:spPr>
          <a:xfrm>
            <a:off x="2264039" y="873208"/>
            <a:ext cx="1107996" cy="207749"/>
          </a:xfrm>
          <a:prstGeom prst="rect">
            <a:avLst/>
          </a:prstGeom>
          <a:noFill/>
        </p:spPr>
        <p:txBody>
          <a:bodyPr wrap="none" rtlCol="0">
            <a:spAutoFit/>
          </a:bodyPr>
          <a:lstStyle/>
          <a:p>
            <a:pPr algn="ctr"/>
            <a:r>
              <a:rPr lang="en-US" sz="750" b="1" dirty="0">
                <a:latin typeface="Arial" panose="020B0604020202020204" pitchFamily="34" charset="0"/>
                <a:cs typeface="Arial" panose="020B0604020202020204" pitchFamily="34" charset="0"/>
              </a:rPr>
              <a:t>900.40 m/z ± 15 ppm</a:t>
            </a:r>
          </a:p>
        </p:txBody>
      </p:sp>
      <p:sp>
        <p:nvSpPr>
          <p:cNvPr id="142" name="TextBox 141">
            <a:extLst>
              <a:ext uri="{FF2B5EF4-FFF2-40B4-BE49-F238E27FC236}">
                <a16:creationId xmlns:a16="http://schemas.microsoft.com/office/drawing/2014/main" id="{25D9CA48-C589-4574-8FB5-B2EC1DB96F8E}"/>
              </a:ext>
            </a:extLst>
          </p:cNvPr>
          <p:cNvSpPr txBox="1"/>
          <p:nvPr/>
        </p:nvSpPr>
        <p:spPr>
          <a:xfrm>
            <a:off x="5159388" y="873208"/>
            <a:ext cx="1160894" cy="207749"/>
          </a:xfrm>
          <a:prstGeom prst="rect">
            <a:avLst/>
          </a:prstGeom>
          <a:noFill/>
        </p:spPr>
        <p:txBody>
          <a:bodyPr wrap="none" rtlCol="0">
            <a:spAutoFit/>
          </a:bodyPr>
          <a:lstStyle/>
          <a:p>
            <a:pPr algn="ctr"/>
            <a:r>
              <a:rPr lang="en-US" sz="750" b="1" dirty="0">
                <a:latin typeface="Arial" panose="020B0604020202020204" pitchFamily="34" charset="0"/>
                <a:cs typeface="Arial" panose="020B0604020202020204" pitchFamily="34" charset="0"/>
              </a:rPr>
              <a:t>1097.53 m/z ± 15 ppm</a:t>
            </a:r>
          </a:p>
        </p:txBody>
      </p:sp>
      <p:sp>
        <p:nvSpPr>
          <p:cNvPr id="2" name="Freeform: Shape 1">
            <a:extLst>
              <a:ext uri="{FF2B5EF4-FFF2-40B4-BE49-F238E27FC236}">
                <a16:creationId xmlns:a16="http://schemas.microsoft.com/office/drawing/2014/main" id="{D31FE0A2-A02F-47E0-9B5E-3019A28699FC}"/>
              </a:ext>
            </a:extLst>
          </p:cNvPr>
          <p:cNvSpPr/>
          <p:nvPr/>
        </p:nvSpPr>
        <p:spPr>
          <a:xfrm>
            <a:off x="602609" y="1072619"/>
            <a:ext cx="1489429" cy="703379"/>
          </a:xfrm>
          <a:custGeom>
            <a:avLst/>
            <a:gdLst>
              <a:gd name="connsiteX0" fmla="*/ 258591 w 1564877"/>
              <a:gd name="connsiteY0" fmla="*/ 130629 h 845087"/>
              <a:gd name="connsiteX1" fmla="*/ 287916 w 1564877"/>
              <a:gd name="connsiteY1" fmla="*/ 191944 h 845087"/>
              <a:gd name="connsiteX2" fmla="*/ 319907 w 1564877"/>
              <a:gd name="connsiteY2" fmla="*/ 229267 h 845087"/>
              <a:gd name="connsiteX3" fmla="*/ 381222 w 1564877"/>
              <a:gd name="connsiteY3" fmla="*/ 274587 h 845087"/>
              <a:gd name="connsiteX4" fmla="*/ 429208 w 1564877"/>
              <a:gd name="connsiteY4" fmla="*/ 309243 h 845087"/>
              <a:gd name="connsiteX5" fmla="*/ 501187 w 1564877"/>
              <a:gd name="connsiteY5" fmla="*/ 391886 h 845087"/>
              <a:gd name="connsiteX6" fmla="*/ 562503 w 1564877"/>
              <a:gd name="connsiteY6" fmla="*/ 426542 h 845087"/>
              <a:gd name="connsiteX7" fmla="*/ 637148 w 1564877"/>
              <a:gd name="connsiteY7" fmla="*/ 463865 h 845087"/>
              <a:gd name="connsiteX8" fmla="*/ 781106 w 1564877"/>
              <a:gd name="connsiteY8" fmla="*/ 493190 h 845087"/>
              <a:gd name="connsiteX9" fmla="*/ 885075 w 1564877"/>
              <a:gd name="connsiteY9" fmla="*/ 493190 h 845087"/>
              <a:gd name="connsiteX10" fmla="*/ 978381 w 1564877"/>
              <a:gd name="connsiteY10" fmla="*/ 490524 h 845087"/>
              <a:gd name="connsiteX11" fmla="*/ 1063690 w 1564877"/>
              <a:gd name="connsiteY11" fmla="*/ 479860 h 845087"/>
              <a:gd name="connsiteX12" fmla="*/ 1087683 w 1564877"/>
              <a:gd name="connsiteY12" fmla="*/ 477194 h 845087"/>
              <a:gd name="connsiteX13" fmla="*/ 1154330 w 1564877"/>
              <a:gd name="connsiteY13" fmla="*/ 469197 h 845087"/>
              <a:gd name="connsiteX14" fmla="*/ 1247636 w 1564877"/>
              <a:gd name="connsiteY14" fmla="*/ 447870 h 845087"/>
              <a:gd name="connsiteX15" fmla="*/ 1274295 w 1564877"/>
              <a:gd name="connsiteY15" fmla="*/ 439872 h 845087"/>
              <a:gd name="connsiteX16" fmla="*/ 1319615 w 1564877"/>
              <a:gd name="connsiteY16" fmla="*/ 434540 h 845087"/>
              <a:gd name="connsiteX17" fmla="*/ 1348940 w 1564877"/>
              <a:gd name="connsiteY17" fmla="*/ 434540 h 845087"/>
              <a:gd name="connsiteX18" fmla="*/ 1375599 w 1564877"/>
              <a:gd name="connsiteY18" fmla="*/ 431874 h 845087"/>
              <a:gd name="connsiteX19" fmla="*/ 1434248 w 1564877"/>
              <a:gd name="connsiteY19" fmla="*/ 434540 h 845087"/>
              <a:gd name="connsiteX20" fmla="*/ 1492898 w 1564877"/>
              <a:gd name="connsiteY20" fmla="*/ 498521 h 845087"/>
              <a:gd name="connsiteX21" fmla="*/ 1540884 w 1564877"/>
              <a:gd name="connsiteY21" fmla="*/ 549173 h 845087"/>
              <a:gd name="connsiteX22" fmla="*/ 1564877 w 1564877"/>
              <a:gd name="connsiteY22" fmla="*/ 615821 h 845087"/>
              <a:gd name="connsiteX23" fmla="*/ 1500896 w 1564877"/>
              <a:gd name="connsiteY23" fmla="*/ 701129 h 845087"/>
              <a:gd name="connsiteX24" fmla="*/ 1482234 w 1564877"/>
              <a:gd name="connsiteY24" fmla="*/ 733120 h 845087"/>
              <a:gd name="connsiteX25" fmla="*/ 1436914 w 1564877"/>
              <a:gd name="connsiteY25" fmla="*/ 770442 h 845087"/>
              <a:gd name="connsiteX26" fmla="*/ 1306286 w 1564877"/>
              <a:gd name="connsiteY26" fmla="*/ 786437 h 845087"/>
              <a:gd name="connsiteX27" fmla="*/ 1162328 w 1564877"/>
              <a:gd name="connsiteY27" fmla="*/ 813096 h 845087"/>
              <a:gd name="connsiteX28" fmla="*/ 1138335 w 1564877"/>
              <a:gd name="connsiteY28" fmla="*/ 813096 h 845087"/>
              <a:gd name="connsiteX29" fmla="*/ 1050360 w 1564877"/>
              <a:gd name="connsiteY29" fmla="*/ 815762 h 845087"/>
              <a:gd name="connsiteX30" fmla="*/ 1007706 w 1564877"/>
              <a:gd name="connsiteY30" fmla="*/ 815762 h 845087"/>
              <a:gd name="connsiteX31" fmla="*/ 965052 w 1564877"/>
              <a:gd name="connsiteY31" fmla="*/ 826426 h 845087"/>
              <a:gd name="connsiteX32" fmla="*/ 815762 w 1564877"/>
              <a:gd name="connsiteY32" fmla="*/ 842421 h 845087"/>
              <a:gd name="connsiteX33" fmla="*/ 773108 w 1564877"/>
              <a:gd name="connsiteY33" fmla="*/ 842421 h 845087"/>
              <a:gd name="connsiteX34" fmla="*/ 693131 w 1564877"/>
              <a:gd name="connsiteY34" fmla="*/ 842421 h 845087"/>
              <a:gd name="connsiteX35" fmla="*/ 562503 w 1564877"/>
              <a:gd name="connsiteY35" fmla="*/ 845087 h 845087"/>
              <a:gd name="connsiteX36" fmla="*/ 538510 w 1564877"/>
              <a:gd name="connsiteY36" fmla="*/ 845087 h 845087"/>
              <a:gd name="connsiteX37" fmla="*/ 415879 w 1564877"/>
              <a:gd name="connsiteY37" fmla="*/ 845087 h 845087"/>
              <a:gd name="connsiteX38" fmla="*/ 338568 w 1564877"/>
              <a:gd name="connsiteY38" fmla="*/ 826426 h 845087"/>
              <a:gd name="connsiteX39" fmla="*/ 226601 w 1564877"/>
              <a:gd name="connsiteY39" fmla="*/ 778440 h 845087"/>
              <a:gd name="connsiteX40" fmla="*/ 93306 w 1564877"/>
              <a:gd name="connsiteY40" fmla="*/ 733120 h 845087"/>
              <a:gd name="connsiteX41" fmla="*/ 10664 w 1564877"/>
              <a:gd name="connsiteY41" fmla="*/ 690465 h 845087"/>
              <a:gd name="connsiteX42" fmla="*/ 0 w 1564877"/>
              <a:gd name="connsiteY42" fmla="*/ 490524 h 845087"/>
              <a:gd name="connsiteX43" fmla="*/ 2666 w 1564877"/>
              <a:gd name="connsiteY43" fmla="*/ 263923 h 845087"/>
              <a:gd name="connsiteX44" fmla="*/ 7998 w 1564877"/>
              <a:gd name="connsiteY44" fmla="*/ 90640 h 845087"/>
              <a:gd name="connsiteX45" fmla="*/ 10664 w 1564877"/>
              <a:gd name="connsiteY45" fmla="*/ 58650 h 845087"/>
              <a:gd name="connsiteX46" fmla="*/ 2666 w 1564877"/>
              <a:gd name="connsiteY46" fmla="*/ 0 h 845087"/>
              <a:gd name="connsiteX47" fmla="*/ 122631 w 1564877"/>
              <a:gd name="connsiteY47" fmla="*/ 26659 h 845087"/>
              <a:gd name="connsiteX48" fmla="*/ 178615 w 1564877"/>
              <a:gd name="connsiteY48" fmla="*/ 55984 h 845087"/>
              <a:gd name="connsiteX49" fmla="*/ 258591 w 1564877"/>
              <a:gd name="connsiteY49" fmla="*/ 130629 h 84508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Lst>
            <a:rect l="l" t="t" r="r" b="b"/>
            <a:pathLst>
              <a:path w="1564877" h="845087">
                <a:moveTo>
                  <a:pt x="258591" y="130629"/>
                </a:moveTo>
                <a:lnTo>
                  <a:pt x="287916" y="191944"/>
                </a:lnTo>
                <a:lnTo>
                  <a:pt x="319907" y="229267"/>
                </a:lnTo>
                <a:lnTo>
                  <a:pt x="381222" y="274587"/>
                </a:lnTo>
                <a:lnTo>
                  <a:pt x="429208" y="309243"/>
                </a:lnTo>
                <a:lnTo>
                  <a:pt x="501187" y="391886"/>
                </a:lnTo>
                <a:lnTo>
                  <a:pt x="562503" y="426542"/>
                </a:lnTo>
                <a:lnTo>
                  <a:pt x="637148" y="463865"/>
                </a:lnTo>
                <a:lnTo>
                  <a:pt x="781106" y="493190"/>
                </a:lnTo>
                <a:lnTo>
                  <a:pt x="885075" y="493190"/>
                </a:lnTo>
                <a:lnTo>
                  <a:pt x="978381" y="490524"/>
                </a:lnTo>
                <a:lnTo>
                  <a:pt x="1063690" y="479860"/>
                </a:lnTo>
                <a:lnTo>
                  <a:pt x="1087683" y="477194"/>
                </a:lnTo>
                <a:lnTo>
                  <a:pt x="1154330" y="469197"/>
                </a:lnTo>
                <a:lnTo>
                  <a:pt x="1247636" y="447870"/>
                </a:lnTo>
                <a:cubicBezTo>
                  <a:pt x="1272856" y="442265"/>
                  <a:pt x="1265836" y="448331"/>
                  <a:pt x="1274295" y="439872"/>
                </a:cubicBezTo>
                <a:lnTo>
                  <a:pt x="1319615" y="434540"/>
                </a:lnTo>
                <a:lnTo>
                  <a:pt x="1348940" y="434540"/>
                </a:lnTo>
                <a:lnTo>
                  <a:pt x="1375599" y="431874"/>
                </a:lnTo>
                <a:lnTo>
                  <a:pt x="1434248" y="434540"/>
                </a:lnTo>
                <a:lnTo>
                  <a:pt x="1492898" y="498521"/>
                </a:lnTo>
                <a:lnTo>
                  <a:pt x="1540884" y="549173"/>
                </a:lnTo>
                <a:lnTo>
                  <a:pt x="1564877" y="615821"/>
                </a:lnTo>
                <a:lnTo>
                  <a:pt x="1500896" y="701129"/>
                </a:lnTo>
                <a:lnTo>
                  <a:pt x="1482234" y="733120"/>
                </a:lnTo>
                <a:lnTo>
                  <a:pt x="1436914" y="770442"/>
                </a:lnTo>
                <a:lnTo>
                  <a:pt x="1306286" y="786437"/>
                </a:lnTo>
                <a:lnTo>
                  <a:pt x="1162328" y="813096"/>
                </a:lnTo>
                <a:lnTo>
                  <a:pt x="1138335" y="813096"/>
                </a:lnTo>
                <a:lnTo>
                  <a:pt x="1050360" y="815762"/>
                </a:lnTo>
                <a:lnTo>
                  <a:pt x="1007706" y="815762"/>
                </a:lnTo>
                <a:lnTo>
                  <a:pt x="965052" y="826426"/>
                </a:lnTo>
                <a:lnTo>
                  <a:pt x="815762" y="842421"/>
                </a:lnTo>
                <a:lnTo>
                  <a:pt x="773108" y="842421"/>
                </a:lnTo>
                <a:lnTo>
                  <a:pt x="693131" y="842421"/>
                </a:lnTo>
                <a:lnTo>
                  <a:pt x="562503" y="845087"/>
                </a:lnTo>
                <a:lnTo>
                  <a:pt x="538510" y="845087"/>
                </a:lnTo>
                <a:lnTo>
                  <a:pt x="415879" y="845087"/>
                </a:lnTo>
                <a:lnTo>
                  <a:pt x="338568" y="826426"/>
                </a:lnTo>
                <a:lnTo>
                  <a:pt x="226601" y="778440"/>
                </a:lnTo>
                <a:lnTo>
                  <a:pt x="93306" y="733120"/>
                </a:lnTo>
                <a:lnTo>
                  <a:pt x="10664" y="690465"/>
                </a:lnTo>
                <a:lnTo>
                  <a:pt x="0" y="490524"/>
                </a:lnTo>
                <a:cubicBezTo>
                  <a:pt x="889" y="414990"/>
                  <a:pt x="1777" y="339457"/>
                  <a:pt x="2666" y="263923"/>
                </a:cubicBezTo>
                <a:lnTo>
                  <a:pt x="7998" y="90640"/>
                </a:lnTo>
                <a:lnTo>
                  <a:pt x="10664" y="58650"/>
                </a:lnTo>
                <a:lnTo>
                  <a:pt x="2666" y="0"/>
                </a:lnTo>
                <a:lnTo>
                  <a:pt x="122631" y="26659"/>
                </a:lnTo>
                <a:lnTo>
                  <a:pt x="178615" y="55984"/>
                </a:lnTo>
                <a:lnTo>
                  <a:pt x="258591" y="130629"/>
                </a:lnTo>
                <a:close/>
              </a:path>
            </a:pathLst>
          </a:custGeom>
          <a:noFill/>
          <a:ln w="28575">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500"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6A92A8E7-DAD4-BB1D-B6EB-1B5A5522D567}"/>
              </a:ext>
            </a:extLst>
          </p:cNvPr>
          <p:cNvSpPr txBox="1"/>
          <p:nvPr/>
        </p:nvSpPr>
        <p:spPr>
          <a:xfrm>
            <a:off x="4670218" y="2295293"/>
            <a:ext cx="793807" cy="356123"/>
          </a:xfrm>
          <a:prstGeom prst="rect">
            <a:avLst/>
          </a:prstGeom>
          <a:noFill/>
        </p:spPr>
        <p:txBody>
          <a:bodyPr wrap="none" rtlCol="0">
            <a:spAutoFit/>
          </a:bodyPr>
          <a:lstStyle/>
          <a:p>
            <a:pPr algn="ctr"/>
            <a:r>
              <a:rPr lang="en-US" sz="857" b="1" dirty="0">
                <a:latin typeface="Arial" panose="020B0604020202020204" pitchFamily="34" charset="0"/>
                <a:cs typeface="Arial" panose="020B0604020202020204" pitchFamily="34" charset="0"/>
              </a:rPr>
              <a:t>COL2A1 </a:t>
            </a:r>
          </a:p>
          <a:p>
            <a:pPr algn="ctr"/>
            <a:r>
              <a:rPr lang="en-US" sz="857" b="1" dirty="0">
                <a:latin typeface="Arial" panose="020B0604020202020204" pitchFamily="34" charset="0"/>
                <a:cs typeface="Arial" panose="020B0604020202020204" pitchFamily="34" charset="0"/>
              </a:rPr>
              <a:t>1097.53 m/z</a:t>
            </a:r>
          </a:p>
        </p:txBody>
      </p:sp>
      <p:sp>
        <p:nvSpPr>
          <p:cNvPr id="57" name="TextBox 56">
            <a:extLst>
              <a:ext uri="{FF2B5EF4-FFF2-40B4-BE49-F238E27FC236}">
                <a16:creationId xmlns:a16="http://schemas.microsoft.com/office/drawing/2014/main" id="{4B4AAFE0-BBEF-4D80-8B87-86198EB20CA4}"/>
              </a:ext>
            </a:extLst>
          </p:cNvPr>
          <p:cNvSpPr txBox="1"/>
          <p:nvPr/>
        </p:nvSpPr>
        <p:spPr>
          <a:xfrm>
            <a:off x="3849488" y="2295293"/>
            <a:ext cx="732893" cy="356123"/>
          </a:xfrm>
          <a:prstGeom prst="rect">
            <a:avLst/>
          </a:prstGeom>
          <a:noFill/>
        </p:spPr>
        <p:txBody>
          <a:bodyPr wrap="none" rtlCol="0">
            <a:spAutoFit/>
          </a:bodyPr>
          <a:lstStyle/>
          <a:p>
            <a:pPr algn="ctr"/>
            <a:r>
              <a:rPr lang="en-US" sz="857" b="1" dirty="0">
                <a:latin typeface="Arial" panose="020B0604020202020204" pitchFamily="34" charset="0"/>
                <a:cs typeface="Arial" panose="020B0604020202020204" pitchFamily="34" charset="0"/>
              </a:rPr>
              <a:t>COL1A1 </a:t>
            </a:r>
          </a:p>
          <a:p>
            <a:pPr algn="ctr"/>
            <a:r>
              <a:rPr lang="en-US" sz="857" b="1" dirty="0">
                <a:latin typeface="Arial" panose="020B0604020202020204" pitchFamily="34" charset="0"/>
                <a:cs typeface="Arial" panose="020B0604020202020204" pitchFamily="34" charset="0"/>
              </a:rPr>
              <a:t>900.41 m/z</a:t>
            </a:r>
          </a:p>
        </p:txBody>
      </p:sp>
      <p:sp>
        <p:nvSpPr>
          <p:cNvPr id="62" name="TextBox 61">
            <a:extLst>
              <a:ext uri="{FF2B5EF4-FFF2-40B4-BE49-F238E27FC236}">
                <a16:creationId xmlns:a16="http://schemas.microsoft.com/office/drawing/2014/main" id="{673C5E9D-7570-B3B1-4B9E-80692E085FDA}"/>
              </a:ext>
            </a:extLst>
          </p:cNvPr>
          <p:cNvSpPr txBox="1"/>
          <p:nvPr/>
        </p:nvSpPr>
        <p:spPr>
          <a:xfrm>
            <a:off x="5508467" y="2295293"/>
            <a:ext cx="753731" cy="356123"/>
          </a:xfrm>
          <a:prstGeom prst="rect">
            <a:avLst/>
          </a:prstGeom>
          <a:noFill/>
        </p:spPr>
        <p:txBody>
          <a:bodyPr wrap="none" rtlCol="0">
            <a:spAutoFit/>
          </a:bodyPr>
          <a:lstStyle/>
          <a:p>
            <a:pPr algn="ctr"/>
            <a:r>
              <a:rPr lang="en-US" sz="857" b="1" dirty="0">
                <a:latin typeface="Arial" panose="020B0604020202020204" pitchFamily="34" charset="0"/>
                <a:cs typeface="Arial" panose="020B0604020202020204" pitchFamily="34" charset="0"/>
              </a:rPr>
              <a:t>Composite</a:t>
            </a:r>
          </a:p>
          <a:p>
            <a:pPr algn="ctr"/>
            <a:r>
              <a:rPr lang="en-US" sz="857" b="1" dirty="0">
                <a:latin typeface="Arial" panose="020B0604020202020204" pitchFamily="34" charset="0"/>
                <a:cs typeface="Arial" panose="020B0604020202020204" pitchFamily="34" charset="0"/>
              </a:rPr>
              <a:t>Image</a:t>
            </a:r>
          </a:p>
        </p:txBody>
      </p:sp>
      <p:sp>
        <p:nvSpPr>
          <p:cNvPr id="163" name="TextBox 162">
            <a:extLst>
              <a:ext uri="{FF2B5EF4-FFF2-40B4-BE49-F238E27FC236}">
                <a16:creationId xmlns:a16="http://schemas.microsoft.com/office/drawing/2014/main" id="{A5123D19-2B1E-B4A5-0D9F-F51A5C0A99B1}"/>
              </a:ext>
            </a:extLst>
          </p:cNvPr>
          <p:cNvSpPr txBox="1"/>
          <p:nvPr/>
        </p:nvSpPr>
        <p:spPr>
          <a:xfrm>
            <a:off x="430821" y="2314144"/>
            <a:ext cx="3145413" cy="290208"/>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B – High Resolution Spatial Distributions</a:t>
            </a:r>
          </a:p>
        </p:txBody>
      </p:sp>
      <p:sp>
        <p:nvSpPr>
          <p:cNvPr id="177" name="Freeform 176">
            <a:extLst>
              <a:ext uri="{FF2B5EF4-FFF2-40B4-BE49-F238E27FC236}">
                <a16:creationId xmlns:a16="http://schemas.microsoft.com/office/drawing/2014/main" id="{0F732036-1D26-7A06-58EC-A25C35451EC1}"/>
              </a:ext>
            </a:extLst>
          </p:cNvPr>
          <p:cNvSpPr/>
          <p:nvPr/>
        </p:nvSpPr>
        <p:spPr>
          <a:xfrm>
            <a:off x="3599764" y="1157949"/>
            <a:ext cx="1145628" cy="366512"/>
          </a:xfrm>
          <a:custGeom>
            <a:avLst/>
            <a:gdLst>
              <a:gd name="connsiteX0" fmla="*/ 53563 w 1511247"/>
              <a:gd name="connsiteY0" fmla="*/ 0 h 493546"/>
              <a:gd name="connsiteX1" fmla="*/ 15304 w 1511247"/>
              <a:gd name="connsiteY1" fmla="*/ 19130 h 493546"/>
              <a:gd name="connsiteX2" fmla="*/ 0 w 1511247"/>
              <a:gd name="connsiteY2" fmla="*/ 26782 h 493546"/>
              <a:gd name="connsiteX3" fmla="*/ 42085 w 1511247"/>
              <a:gd name="connsiteY3" fmla="*/ 68867 h 493546"/>
              <a:gd name="connsiteX4" fmla="*/ 107126 w 1511247"/>
              <a:gd name="connsiteY4" fmla="*/ 133908 h 493546"/>
              <a:gd name="connsiteX5" fmla="*/ 168341 w 1511247"/>
              <a:gd name="connsiteY5" fmla="*/ 187471 h 493546"/>
              <a:gd name="connsiteX6" fmla="*/ 263990 w 1511247"/>
              <a:gd name="connsiteY6" fmla="*/ 275468 h 493546"/>
              <a:gd name="connsiteX7" fmla="*/ 340509 w 1511247"/>
              <a:gd name="connsiteY7" fmla="*/ 336683 h 493546"/>
              <a:gd name="connsiteX8" fmla="*/ 443809 w 1511247"/>
              <a:gd name="connsiteY8" fmla="*/ 409376 h 493546"/>
              <a:gd name="connsiteX9" fmla="*/ 547110 w 1511247"/>
              <a:gd name="connsiteY9" fmla="*/ 451461 h 493546"/>
              <a:gd name="connsiteX10" fmla="*/ 700147 w 1511247"/>
              <a:gd name="connsiteY10" fmla="*/ 474417 h 493546"/>
              <a:gd name="connsiteX11" fmla="*/ 868489 w 1511247"/>
              <a:gd name="connsiteY11" fmla="*/ 493546 h 493546"/>
              <a:gd name="connsiteX12" fmla="*/ 1029178 w 1511247"/>
              <a:gd name="connsiteY12" fmla="*/ 482069 h 493546"/>
              <a:gd name="connsiteX13" fmla="*/ 1220475 w 1511247"/>
              <a:gd name="connsiteY13" fmla="*/ 459113 h 493546"/>
              <a:gd name="connsiteX14" fmla="*/ 1415598 w 1511247"/>
              <a:gd name="connsiteY14" fmla="*/ 436157 h 493546"/>
              <a:gd name="connsiteX15" fmla="*/ 1495943 w 1511247"/>
              <a:gd name="connsiteY15" fmla="*/ 420853 h 493546"/>
              <a:gd name="connsiteX16" fmla="*/ 1511247 w 1511247"/>
              <a:gd name="connsiteY16" fmla="*/ 374942 h 493546"/>
              <a:gd name="connsiteX17" fmla="*/ 1480639 w 1511247"/>
              <a:gd name="connsiteY17" fmla="*/ 329031 h 493546"/>
              <a:gd name="connsiteX18" fmla="*/ 1438554 w 1511247"/>
              <a:gd name="connsiteY18" fmla="*/ 306075 h 493546"/>
              <a:gd name="connsiteX19" fmla="*/ 1358209 w 1511247"/>
              <a:gd name="connsiteY19" fmla="*/ 332857 h 493546"/>
              <a:gd name="connsiteX20" fmla="*/ 1216649 w 1511247"/>
              <a:gd name="connsiteY20" fmla="*/ 351987 h 493546"/>
              <a:gd name="connsiteX21" fmla="*/ 1082741 w 1511247"/>
              <a:gd name="connsiteY21" fmla="*/ 348161 h 493546"/>
              <a:gd name="connsiteX22" fmla="*/ 864663 w 1511247"/>
              <a:gd name="connsiteY22" fmla="*/ 340509 h 493546"/>
              <a:gd name="connsiteX23" fmla="*/ 684844 w 1511247"/>
              <a:gd name="connsiteY23" fmla="*/ 309901 h 493546"/>
              <a:gd name="connsiteX24" fmla="*/ 608325 w 1511247"/>
              <a:gd name="connsiteY24" fmla="*/ 298423 h 493546"/>
              <a:gd name="connsiteX25" fmla="*/ 462939 w 1511247"/>
              <a:gd name="connsiteY25" fmla="*/ 229556 h 493546"/>
              <a:gd name="connsiteX26" fmla="*/ 344335 w 1511247"/>
              <a:gd name="connsiteY26" fmla="*/ 156864 h 493546"/>
              <a:gd name="connsiteX27" fmla="*/ 244860 w 1511247"/>
              <a:gd name="connsiteY27" fmla="*/ 87997 h 493546"/>
              <a:gd name="connsiteX28" fmla="*/ 172167 w 1511247"/>
              <a:gd name="connsiteY28" fmla="*/ 49737 h 493546"/>
              <a:gd name="connsiteX29" fmla="*/ 130082 w 1511247"/>
              <a:gd name="connsiteY29" fmla="*/ 26782 h 493546"/>
              <a:gd name="connsiteX30" fmla="*/ 53563 w 1511247"/>
              <a:gd name="connsiteY30" fmla="*/ 0 h 49354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Lst>
            <a:rect l="l" t="t" r="r" b="b"/>
            <a:pathLst>
              <a:path w="1511247" h="493546">
                <a:moveTo>
                  <a:pt x="53563" y="0"/>
                </a:moveTo>
                <a:lnTo>
                  <a:pt x="15304" y="19130"/>
                </a:lnTo>
                <a:lnTo>
                  <a:pt x="0" y="26782"/>
                </a:lnTo>
                <a:lnTo>
                  <a:pt x="42085" y="68867"/>
                </a:lnTo>
                <a:lnTo>
                  <a:pt x="107126" y="133908"/>
                </a:lnTo>
                <a:lnTo>
                  <a:pt x="168341" y="187471"/>
                </a:lnTo>
                <a:lnTo>
                  <a:pt x="263990" y="275468"/>
                </a:lnTo>
                <a:lnTo>
                  <a:pt x="340509" y="336683"/>
                </a:lnTo>
                <a:lnTo>
                  <a:pt x="443809" y="409376"/>
                </a:lnTo>
                <a:lnTo>
                  <a:pt x="547110" y="451461"/>
                </a:lnTo>
                <a:lnTo>
                  <a:pt x="700147" y="474417"/>
                </a:lnTo>
                <a:lnTo>
                  <a:pt x="868489" y="493546"/>
                </a:lnTo>
                <a:lnTo>
                  <a:pt x="1029178" y="482069"/>
                </a:lnTo>
                <a:lnTo>
                  <a:pt x="1220475" y="459113"/>
                </a:lnTo>
                <a:lnTo>
                  <a:pt x="1415598" y="436157"/>
                </a:lnTo>
                <a:lnTo>
                  <a:pt x="1495943" y="420853"/>
                </a:lnTo>
                <a:lnTo>
                  <a:pt x="1511247" y="374942"/>
                </a:lnTo>
                <a:lnTo>
                  <a:pt x="1480639" y="329031"/>
                </a:lnTo>
                <a:lnTo>
                  <a:pt x="1438554" y="306075"/>
                </a:lnTo>
                <a:lnTo>
                  <a:pt x="1358209" y="332857"/>
                </a:lnTo>
                <a:lnTo>
                  <a:pt x="1216649" y="351987"/>
                </a:lnTo>
                <a:lnTo>
                  <a:pt x="1082741" y="348161"/>
                </a:lnTo>
                <a:lnTo>
                  <a:pt x="864663" y="340509"/>
                </a:lnTo>
                <a:lnTo>
                  <a:pt x="684844" y="309901"/>
                </a:lnTo>
                <a:lnTo>
                  <a:pt x="608325" y="298423"/>
                </a:lnTo>
                <a:lnTo>
                  <a:pt x="462939" y="229556"/>
                </a:lnTo>
                <a:lnTo>
                  <a:pt x="344335" y="156864"/>
                </a:lnTo>
                <a:lnTo>
                  <a:pt x="244860" y="87997"/>
                </a:lnTo>
                <a:lnTo>
                  <a:pt x="172167" y="49737"/>
                </a:lnTo>
                <a:lnTo>
                  <a:pt x="130082" y="26782"/>
                </a:lnTo>
                <a:lnTo>
                  <a:pt x="53563" y="0"/>
                </a:lnTo>
                <a:close/>
              </a:path>
            </a:pathLst>
          </a:custGeom>
          <a:noFill/>
          <a:ln w="19050">
            <a:solidFill>
              <a:srgbClr val="FFFF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929"/>
          </a:p>
        </p:txBody>
      </p:sp>
      <p:grpSp>
        <p:nvGrpSpPr>
          <p:cNvPr id="178" name="Group 177">
            <a:extLst>
              <a:ext uri="{FF2B5EF4-FFF2-40B4-BE49-F238E27FC236}">
                <a16:creationId xmlns:a16="http://schemas.microsoft.com/office/drawing/2014/main" id="{43557FBD-5429-4C6C-8C94-CA6C921055B9}"/>
              </a:ext>
            </a:extLst>
          </p:cNvPr>
          <p:cNvGrpSpPr/>
          <p:nvPr/>
        </p:nvGrpSpPr>
        <p:grpSpPr>
          <a:xfrm>
            <a:off x="495383" y="4698613"/>
            <a:ext cx="5781921" cy="4302674"/>
            <a:chOff x="956366" y="402393"/>
            <a:chExt cx="8558815" cy="6062427"/>
          </a:xfrm>
        </p:grpSpPr>
        <p:pic>
          <p:nvPicPr>
            <p:cNvPr id="179" name="Picture 178">
              <a:extLst>
                <a:ext uri="{FF2B5EF4-FFF2-40B4-BE49-F238E27FC236}">
                  <a16:creationId xmlns:a16="http://schemas.microsoft.com/office/drawing/2014/main" id="{D49E97FE-1672-03E3-2247-E0F87FDBE20C}"/>
                </a:ext>
              </a:extLst>
            </p:cNvPr>
            <p:cNvPicPr>
              <a:picLocks noChangeAspect="1"/>
            </p:cNvPicPr>
            <p:nvPr/>
          </p:nvPicPr>
          <p:blipFill rotWithShape="1">
            <a:blip r:embed="rId10"/>
            <a:srcRect l="27389" t="4134" r="42434" b="3439"/>
            <a:stretch/>
          </p:blipFill>
          <p:spPr>
            <a:xfrm>
              <a:off x="981075" y="440493"/>
              <a:ext cx="2857397" cy="5365870"/>
            </a:xfrm>
            <a:prstGeom prst="rect">
              <a:avLst/>
            </a:prstGeom>
          </p:spPr>
        </p:pic>
        <p:pic>
          <p:nvPicPr>
            <p:cNvPr id="180" name="Picture 179">
              <a:extLst>
                <a:ext uri="{FF2B5EF4-FFF2-40B4-BE49-F238E27FC236}">
                  <a16:creationId xmlns:a16="http://schemas.microsoft.com/office/drawing/2014/main" id="{9BEC28AA-B0EC-B59B-9A58-F0CB8C9A9AA4}"/>
                </a:ext>
              </a:extLst>
            </p:cNvPr>
            <p:cNvPicPr>
              <a:picLocks noChangeAspect="1"/>
            </p:cNvPicPr>
            <p:nvPr/>
          </p:nvPicPr>
          <p:blipFill rotWithShape="1">
            <a:blip r:embed="rId10"/>
            <a:srcRect l="61219" t="88347"/>
            <a:stretch/>
          </p:blipFill>
          <p:spPr>
            <a:xfrm>
              <a:off x="1049531" y="5799889"/>
              <a:ext cx="2783286" cy="512757"/>
            </a:xfrm>
            <a:prstGeom prst="rect">
              <a:avLst/>
            </a:prstGeom>
          </p:spPr>
        </p:pic>
        <p:pic>
          <p:nvPicPr>
            <p:cNvPr id="181" name="Picture 180">
              <a:extLst>
                <a:ext uri="{FF2B5EF4-FFF2-40B4-BE49-F238E27FC236}">
                  <a16:creationId xmlns:a16="http://schemas.microsoft.com/office/drawing/2014/main" id="{8BEBD7C2-DE72-E9EB-A936-0567C71F7985}"/>
                </a:ext>
              </a:extLst>
            </p:cNvPr>
            <p:cNvPicPr>
              <a:picLocks noChangeAspect="1"/>
            </p:cNvPicPr>
            <p:nvPr/>
          </p:nvPicPr>
          <p:blipFill rotWithShape="1">
            <a:blip r:embed="rId10"/>
            <a:srcRect l="776" t="92702" r="89048" b="1679"/>
            <a:stretch/>
          </p:blipFill>
          <p:spPr>
            <a:xfrm>
              <a:off x="956366" y="6138627"/>
              <a:ext cx="963446" cy="326193"/>
            </a:xfrm>
            <a:prstGeom prst="rect">
              <a:avLst/>
            </a:prstGeom>
          </p:spPr>
        </p:pic>
        <p:pic>
          <p:nvPicPr>
            <p:cNvPr id="182" name="Picture 181">
              <a:extLst>
                <a:ext uri="{FF2B5EF4-FFF2-40B4-BE49-F238E27FC236}">
                  <a16:creationId xmlns:a16="http://schemas.microsoft.com/office/drawing/2014/main" id="{316D7C31-B26F-3C7E-2A3F-154EBF3FBB86}"/>
                </a:ext>
              </a:extLst>
            </p:cNvPr>
            <p:cNvPicPr>
              <a:picLocks noChangeAspect="1"/>
            </p:cNvPicPr>
            <p:nvPr/>
          </p:nvPicPr>
          <p:blipFill rotWithShape="1">
            <a:blip r:embed="rId11"/>
            <a:srcRect l="27736" t="4629" r="42869" b="2943"/>
            <a:stretch/>
          </p:blipFill>
          <p:spPr>
            <a:xfrm>
              <a:off x="6731895" y="455771"/>
              <a:ext cx="2783286" cy="5365871"/>
            </a:xfrm>
            <a:prstGeom prst="rect">
              <a:avLst/>
            </a:prstGeom>
          </p:spPr>
        </p:pic>
        <p:pic>
          <p:nvPicPr>
            <p:cNvPr id="183" name="Picture 182">
              <a:extLst>
                <a:ext uri="{FF2B5EF4-FFF2-40B4-BE49-F238E27FC236}">
                  <a16:creationId xmlns:a16="http://schemas.microsoft.com/office/drawing/2014/main" id="{3163163C-D59E-E4AE-AC32-A035C1D11558}"/>
                </a:ext>
              </a:extLst>
            </p:cNvPr>
            <p:cNvPicPr>
              <a:picLocks noChangeAspect="1"/>
            </p:cNvPicPr>
            <p:nvPr/>
          </p:nvPicPr>
          <p:blipFill rotWithShape="1">
            <a:blip r:embed="rId11"/>
            <a:srcRect l="60958" t="88769"/>
            <a:stretch/>
          </p:blipFill>
          <p:spPr>
            <a:xfrm>
              <a:off x="6731895" y="5810813"/>
              <a:ext cx="2783286" cy="490911"/>
            </a:xfrm>
            <a:prstGeom prst="rect">
              <a:avLst/>
            </a:prstGeom>
          </p:spPr>
        </p:pic>
        <p:pic>
          <p:nvPicPr>
            <p:cNvPr id="184" name="Picture 183">
              <a:extLst>
                <a:ext uri="{FF2B5EF4-FFF2-40B4-BE49-F238E27FC236}">
                  <a16:creationId xmlns:a16="http://schemas.microsoft.com/office/drawing/2014/main" id="{12F213C5-3366-EECC-EE37-A062A88D8D84}"/>
                </a:ext>
              </a:extLst>
            </p:cNvPr>
            <p:cNvPicPr>
              <a:picLocks noChangeAspect="1"/>
            </p:cNvPicPr>
            <p:nvPr/>
          </p:nvPicPr>
          <p:blipFill rotWithShape="1">
            <a:blip r:embed="rId12"/>
            <a:srcRect l="27910" t="3646" r="42695" b="3927"/>
            <a:stretch/>
          </p:blipFill>
          <p:spPr>
            <a:xfrm>
              <a:off x="3887885" y="402393"/>
              <a:ext cx="2783286" cy="5365872"/>
            </a:xfrm>
            <a:prstGeom prst="rect">
              <a:avLst/>
            </a:prstGeom>
          </p:spPr>
        </p:pic>
        <p:pic>
          <p:nvPicPr>
            <p:cNvPr id="185" name="Picture 184">
              <a:extLst>
                <a:ext uri="{FF2B5EF4-FFF2-40B4-BE49-F238E27FC236}">
                  <a16:creationId xmlns:a16="http://schemas.microsoft.com/office/drawing/2014/main" id="{432FD3BE-6B4E-6BD4-4CA8-923E73C76C93}"/>
                </a:ext>
              </a:extLst>
            </p:cNvPr>
            <p:cNvPicPr>
              <a:picLocks noChangeAspect="1"/>
            </p:cNvPicPr>
            <p:nvPr/>
          </p:nvPicPr>
          <p:blipFill rotWithShape="1">
            <a:blip r:embed="rId12"/>
            <a:srcRect l="62088" t="88628"/>
            <a:stretch/>
          </p:blipFill>
          <p:spPr>
            <a:xfrm>
              <a:off x="3887886" y="5789851"/>
              <a:ext cx="2783286" cy="511873"/>
            </a:xfrm>
            <a:prstGeom prst="rect">
              <a:avLst/>
            </a:prstGeom>
          </p:spPr>
        </p:pic>
      </p:grpSp>
      <p:sp>
        <p:nvSpPr>
          <p:cNvPr id="186" name="TextBox 185">
            <a:extLst>
              <a:ext uri="{FF2B5EF4-FFF2-40B4-BE49-F238E27FC236}">
                <a16:creationId xmlns:a16="http://schemas.microsoft.com/office/drawing/2014/main" id="{CC7B4244-2FC2-5939-DE18-A8CC574455C4}"/>
              </a:ext>
            </a:extLst>
          </p:cNvPr>
          <p:cNvSpPr txBox="1"/>
          <p:nvPr/>
        </p:nvSpPr>
        <p:spPr>
          <a:xfrm>
            <a:off x="2602291" y="4502295"/>
            <a:ext cx="1653418" cy="290208"/>
          </a:xfrm>
          <a:prstGeom prst="rect">
            <a:avLst/>
          </a:prstGeom>
          <a:noFill/>
        </p:spPr>
        <p:txBody>
          <a:bodyPr wrap="square" rtlCol="0">
            <a:spAutoFit/>
          </a:bodyPr>
          <a:lstStyle/>
          <a:p>
            <a:pPr algn="ctr"/>
            <a:r>
              <a:rPr lang="en-US" sz="1286" dirty="0">
                <a:latin typeface="Arial" panose="020B0604020202020204" pitchFamily="34" charset="0"/>
                <a:cs typeface="Arial" panose="020B0604020202020204" pitchFamily="34" charset="0"/>
              </a:rPr>
              <a:t>1406.71 m/z</a:t>
            </a:r>
          </a:p>
        </p:txBody>
      </p:sp>
      <p:sp>
        <p:nvSpPr>
          <p:cNvPr id="187" name="TextBox 186">
            <a:extLst>
              <a:ext uri="{FF2B5EF4-FFF2-40B4-BE49-F238E27FC236}">
                <a16:creationId xmlns:a16="http://schemas.microsoft.com/office/drawing/2014/main" id="{A59FDC48-FC54-5272-7214-BCEDCB4B064E}"/>
              </a:ext>
            </a:extLst>
          </p:cNvPr>
          <p:cNvSpPr txBox="1"/>
          <p:nvPr/>
        </p:nvSpPr>
        <p:spPr>
          <a:xfrm>
            <a:off x="572371" y="4504997"/>
            <a:ext cx="1866203" cy="290208"/>
          </a:xfrm>
          <a:prstGeom prst="rect">
            <a:avLst/>
          </a:prstGeom>
          <a:noFill/>
        </p:spPr>
        <p:txBody>
          <a:bodyPr wrap="square" rtlCol="0">
            <a:spAutoFit/>
          </a:bodyPr>
          <a:lstStyle/>
          <a:p>
            <a:pPr algn="ctr"/>
            <a:r>
              <a:rPr lang="en-US" sz="1286" dirty="0">
                <a:latin typeface="Arial" panose="020B0604020202020204" pitchFamily="34" charset="0"/>
                <a:cs typeface="Arial" panose="020B0604020202020204" pitchFamily="34" charset="0"/>
              </a:rPr>
              <a:t>1943.91 m/z</a:t>
            </a:r>
          </a:p>
        </p:txBody>
      </p:sp>
      <p:sp>
        <p:nvSpPr>
          <p:cNvPr id="188" name="TextBox 187">
            <a:extLst>
              <a:ext uri="{FF2B5EF4-FFF2-40B4-BE49-F238E27FC236}">
                <a16:creationId xmlns:a16="http://schemas.microsoft.com/office/drawing/2014/main" id="{C8D81651-644E-332D-44DA-66921E5D0062}"/>
              </a:ext>
            </a:extLst>
          </p:cNvPr>
          <p:cNvSpPr txBox="1"/>
          <p:nvPr/>
        </p:nvSpPr>
        <p:spPr>
          <a:xfrm>
            <a:off x="4521294" y="4502295"/>
            <a:ext cx="1653418" cy="290208"/>
          </a:xfrm>
          <a:prstGeom prst="rect">
            <a:avLst/>
          </a:prstGeom>
          <a:noFill/>
        </p:spPr>
        <p:txBody>
          <a:bodyPr wrap="square" rtlCol="0">
            <a:spAutoFit/>
          </a:bodyPr>
          <a:lstStyle/>
          <a:p>
            <a:pPr algn="ctr"/>
            <a:r>
              <a:rPr lang="en-US" sz="1286" dirty="0">
                <a:latin typeface="Arial" panose="020B0604020202020204" pitchFamily="34" charset="0"/>
                <a:cs typeface="Arial" panose="020B0604020202020204" pitchFamily="34" charset="0"/>
              </a:rPr>
              <a:t>1242.58 m/z</a:t>
            </a:r>
          </a:p>
        </p:txBody>
      </p:sp>
      <p:sp>
        <p:nvSpPr>
          <p:cNvPr id="190" name="TextBox 189">
            <a:extLst>
              <a:ext uri="{FF2B5EF4-FFF2-40B4-BE49-F238E27FC236}">
                <a16:creationId xmlns:a16="http://schemas.microsoft.com/office/drawing/2014/main" id="{C5ACC484-A9DB-A0F0-0DE6-74E2CF130B89}"/>
              </a:ext>
            </a:extLst>
          </p:cNvPr>
          <p:cNvSpPr txBox="1"/>
          <p:nvPr/>
        </p:nvSpPr>
        <p:spPr>
          <a:xfrm>
            <a:off x="460712" y="4268627"/>
            <a:ext cx="4827540" cy="290208"/>
          </a:xfrm>
          <a:prstGeom prst="rect">
            <a:avLst/>
          </a:prstGeom>
          <a:noFill/>
        </p:spPr>
        <p:txBody>
          <a:bodyPr wrap="none" rtlCol="0">
            <a:spAutoFit/>
          </a:bodyPr>
          <a:lstStyle/>
          <a:p>
            <a:r>
              <a:rPr lang="en-US" sz="1286" dirty="0">
                <a:latin typeface="Arial" panose="020B0604020202020204" pitchFamily="34" charset="0"/>
                <a:cs typeface="Arial" panose="020B0604020202020204" pitchFamily="34" charset="0"/>
              </a:rPr>
              <a:t>C – Unique Molecular Patterns in Subchondral Trabecular Bone</a:t>
            </a:r>
          </a:p>
        </p:txBody>
      </p:sp>
      <p:pic>
        <p:nvPicPr>
          <p:cNvPr id="64" name="Picture 63">
            <a:extLst>
              <a:ext uri="{FF2B5EF4-FFF2-40B4-BE49-F238E27FC236}">
                <a16:creationId xmlns:a16="http://schemas.microsoft.com/office/drawing/2014/main" id="{3375673D-662A-493C-8E5E-307526BC9F91}"/>
              </a:ext>
            </a:extLst>
          </p:cNvPr>
          <p:cNvPicPr>
            <a:picLocks noChangeAspect="1"/>
          </p:cNvPicPr>
          <p:nvPr/>
        </p:nvPicPr>
        <p:blipFill rotWithShape="1">
          <a:blip r:embed="rId13"/>
          <a:srcRect l="36854" t="9953" r="37096" b="21835"/>
          <a:stretch/>
        </p:blipFill>
        <p:spPr>
          <a:xfrm>
            <a:off x="4650314" y="2605483"/>
            <a:ext cx="799527" cy="1328239"/>
          </a:xfrm>
          <a:prstGeom prst="rect">
            <a:avLst/>
          </a:prstGeom>
        </p:spPr>
      </p:pic>
      <p:pic>
        <p:nvPicPr>
          <p:cNvPr id="66" name="Picture 65">
            <a:extLst>
              <a:ext uri="{FF2B5EF4-FFF2-40B4-BE49-F238E27FC236}">
                <a16:creationId xmlns:a16="http://schemas.microsoft.com/office/drawing/2014/main" id="{D5299B5F-FB97-40CC-B923-D0EF0B50B31F}"/>
              </a:ext>
            </a:extLst>
          </p:cNvPr>
          <p:cNvPicPr>
            <a:picLocks noChangeAspect="1"/>
          </p:cNvPicPr>
          <p:nvPr/>
        </p:nvPicPr>
        <p:blipFill rotWithShape="1">
          <a:blip r:embed="rId14"/>
          <a:srcRect l="36729" t="9952" r="37222" b="21836"/>
          <a:stretch/>
        </p:blipFill>
        <p:spPr>
          <a:xfrm>
            <a:off x="3821543" y="2605483"/>
            <a:ext cx="799527" cy="1328239"/>
          </a:xfrm>
          <a:prstGeom prst="rect">
            <a:avLst/>
          </a:prstGeom>
        </p:spPr>
      </p:pic>
      <p:pic>
        <p:nvPicPr>
          <p:cNvPr id="67" name="Picture 66">
            <a:extLst>
              <a:ext uri="{FF2B5EF4-FFF2-40B4-BE49-F238E27FC236}">
                <a16:creationId xmlns:a16="http://schemas.microsoft.com/office/drawing/2014/main" id="{B10E0855-FBF5-4750-BB1C-CE5BA6523CA1}"/>
              </a:ext>
            </a:extLst>
          </p:cNvPr>
          <p:cNvPicPr>
            <a:picLocks noChangeAspect="1"/>
          </p:cNvPicPr>
          <p:nvPr/>
        </p:nvPicPr>
        <p:blipFill rotWithShape="1">
          <a:blip r:embed="rId15"/>
          <a:srcRect l="36505" t="9953" r="37446" b="21835"/>
          <a:stretch/>
        </p:blipFill>
        <p:spPr>
          <a:xfrm>
            <a:off x="5477102" y="2605484"/>
            <a:ext cx="799527" cy="1328238"/>
          </a:xfrm>
          <a:prstGeom prst="rect">
            <a:avLst/>
          </a:prstGeom>
        </p:spPr>
      </p:pic>
      <p:sp>
        <p:nvSpPr>
          <p:cNvPr id="68" name="TextBox 67">
            <a:extLst>
              <a:ext uri="{FF2B5EF4-FFF2-40B4-BE49-F238E27FC236}">
                <a16:creationId xmlns:a16="http://schemas.microsoft.com/office/drawing/2014/main" id="{D097E150-83A9-4E2D-AB85-E3E0FC09F458}"/>
              </a:ext>
            </a:extLst>
          </p:cNvPr>
          <p:cNvSpPr txBox="1"/>
          <p:nvPr/>
        </p:nvSpPr>
        <p:spPr>
          <a:xfrm>
            <a:off x="3930865" y="3908904"/>
            <a:ext cx="610636" cy="265457"/>
          </a:xfrm>
          <a:prstGeom prst="rect">
            <a:avLst/>
          </a:prstGeom>
          <a:noFill/>
        </p:spPr>
        <p:txBody>
          <a:bodyPr wrap="square" rtlCol="0">
            <a:spAutoFit/>
          </a:bodyPr>
          <a:lstStyle/>
          <a:p>
            <a:r>
              <a:rPr lang="en-US" sz="1125" b="1" dirty="0">
                <a:latin typeface="Arial" panose="020B0604020202020204" pitchFamily="34" charset="0"/>
                <a:cs typeface="Arial" panose="020B0604020202020204" pitchFamily="34" charset="0"/>
              </a:rPr>
              <a:t>1 mm</a:t>
            </a:r>
          </a:p>
        </p:txBody>
      </p:sp>
      <p:grpSp>
        <p:nvGrpSpPr>
          <p:cNvPr id="69" name="Group 68">
            <a:extLst>
              <a:ext uri="{FF2B5EF4-FFF2-40B4-BE49-F238E27FC236}">
                <a16:creationId xmlns:a16="http://schemas.microsoft.com/office/drawing/2014/main" id="{BD72FECB-2269-4EC1-9875-C1D6FB280C5B}"/>
              </a:ext>
            </a:extLst>
          </p:cNvPr>
          <p:cNvGrpSpPr/>
          <p:nvPr/>
        </p:nvGrpSpPr>
        <p:grpSpPr>
          <a:xfrm>
            <a:off x="3813309" y="4005788"/>
            <a:ext cx="155031" cy="94532"/>
            <a:chOff x="216701" y="2995736"/>
            <a:chExt cx="215470" cy="83641"/>
          </a:xfrm>
        </p:grpSpPr>
        <p:cxnSp>
          <p:nvCxnSpPr>
            <p:cNvPr id="89" name="Straight Connector 88">
              <a:extLst>
                <a:ext uri="{FF2B5EF4-FFF2-40B4-BE49-F238E27FC236}">
                  <a16:creationId xmlns:a16="http://schemas.microsoft.com/office/drawing/2014/main" id="{94958D01-9107-4BC3-A092-0FE0F3205D97}"/>
                </a:ext>
              </a:extLst>
            </p:cNvPr>
            <p:cNvCxnSpPr>
              <a:cxnSpLocks/>
            </p:cNvCxnSpPr>
            <p:nvPr/>
          </p:nvCxnSpPr>
          <p:spPr>
            <a:xfrm>
              <a:off x="216701"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a:extLst>
                <a:ext uri="{FF2B5EF4-FFF2-40B4-BE49-F238E27FC236}">
                  <a16:creationId xmlns:a16="http://schemas.microsoft.com/office/drawing/2014/main" id="{40605BD3-E1DD-4100-8A76-8F6C28BC9C38}"/>
                </a:ext>
              </a:extLst>
            </p:cNvPr>
            <p:cNvCxnSpPr>
              <a:cxnSpLocks/>
            </p:cNvCxnSpPr>
            <p:nvPr/>
          </p:nvCxnSpPr>
          <p:spPr>
            <a:xfrm>
              <a:off x="432171"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9F8F55F8-110F-4581-A86B-1838AE07DCAB}"/>
                </a:ext>
              </a:extLst>
            </p:cNvPr>
            <p:cNvCxnSpPr>
              <a:cxnSpLocks/>
            </p:cNvCxnSpPr>
            <p:nvPr/>
          </p:nvCxnSpPr>
          <p:spPr>
            <a:xfrm flipH="1">
              <a:off x="216701" y="3037551"/>
              <a:ext cx="21547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82" name="Picture 81">
            <a:extLst>
              <a:ext uri="{FF2B5EF4-FFF2-40B4-BE49-F238E27FC236}">
                <a16:creationId xmlns:a16="http://schemas.microsoft.com/office/drawing/2014/main" id="{4A1DD0D5-6159-4274-9E72-C41E18ADF88E}"/>
              </a:ext>
            </a:extLst>
          </p:cNvPr>
          <p:cNvPicPr>
            <a:picLocks noChangeAspect="1"/>
          </p:cNvPicPr>
          <p:nvPr/>
        </p:nvPicPr>
        <p:blipFill rotWithShape="1">
          <a:blip r:embed="rId16"/>
          <a:srcRect l="18489" t="18839" r="10859"/>
          <a:stretch/>
        </p:blipFill>
        <p:spPr>
          <a:xfrm>
            <a:off x="540884" y="2603921"/>
            <a:ext cx="3238420" cy="1328712"/>
          </a:xfrm>
          <a:prstGeom prst="rect">
            <a:avLst/>
          </a:prstGeom>
        </p:spPr>
      </p:pic>
      <p:sp>
        <p:nvSpPr>
          <p:cNvPr id="83" name="Rectangle 82">
            <a:extLst>
              <a:ext uri="{FF2B5EF4-FFF2-40B4-BE49-F238E27FC236}">
                <a16:creationId xmlns:a16="http://schemas.microsoft.com/office/drawing/2014/main" id="{E4380B12-63FC-4C6D-AC97-7D5D6B2A7AEE}"/>
              </a:ext>
            </a:extLst>
          </p:cNvPr>
          <p:cNvSpPr/>
          <p:nvPr/>
        </p:nvSpPr>
        <p:spPr>
          <a:xfrm>
            <a:off x="2382808" y="2853580"/>
            <a:ext cx="280446" cy="437672"/>
          </a:xfrm>
          <a:prstGeom prst="rect">
            <a:avLst/>
          </a:prstGeom>
          <a:noFill/>
          <a:ln w="1905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en-US" sz="536" b="1" dirty="0">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E7FFD8E9-C939-4450-9A08-9E562BF71700}"/>
              </a:ext>
            </a:extLst>
          </p:cNvPr>
          <p:cNvSpPr txBox="1"/>
          <p:nvPr/>
        </p:nvSpPr>
        <p:spPr>
          <a:xfrm>
            <a:off x="948459" y="3932633"/>
            <a:ext cx="561372" cy="265457"/>
          </a:xfrm>
          <a:prstGeom prst="rect">
            <a:avLst/>
          </a:prstGeom>
          <a:noFill/>
        </p:spPr>
        <p:txBody>
          <a:bodyPr wrap="none" rtlCol="0">
            <a:spAutoFit/>
          </a:bodyPr>
          <a:lstStyle/>
          <a:p>
            <a:r>
              <a:rPr lang="en-US" sz="1125" b="1" dirty="0">
                <a:latin typeface="Arial" panose="020B0604020202020204" pitchFamily="34" charset="0"/>
                <a:cs typeface="Arial" panose="020B0604020202020204" pitchFamily="34" charset="0"/>
              </a:rPr>
              <a:t>5 mm</a:t>
            </a:r>
          </a:p>
        </p:txBody>
      </p:sp>
      <p:grpSp>
        <p:nvGrpSpPr>
          <p:cNvPr id="85" name="Group 84">
            <a:extLst>
              <a:ext uri="{FF2B5EF4-FFF2-40B4-BE49-F238E27FC236}">
                <a16:creationId xmlns:a16="http://schemas.microsoft.com/office/drawing/2014/main" id="{E75FFC7C-1428-49C9-ABBE-42131B093F5F}"/>
              </a:ext>
            </a:extLst>
          </p:cNvPr>
          <p:cNvGrpSpPr/>
          <p:nvPr/>
        </p:nvGrpSpPr>
        <p:grpSpPr>
          <a:xfrm>
            <a:off x="548349" y="3998589"/>
            <a:ext cx="436362" cy="135128"/>
            <a:chOff x="216701" y="2995736"/>
            <a:chExt cx="429171" cy="83641"/>
          </a:xfrm>
        </p:grpSpPr>
        <p:cxnSp>
          <p:nvCxnSpPr>
            <p:cNvPr id="86" name="Straight Connector 85">
              <a:extLst>
                <a:ext uri="{FF2B5EF4-FFF2-40B4-BE49-F238E27FC236}">
                  <a16:creationId xmlns:a16="http://schemas.microsoft.com/office/drawing/2014/main" id="{3B9FDCBB-4277-444A-A363-8F6D328A6A7E}"/>
                </a:ext>
              </a:extLst>
            </p:cNvPr>
            <p:cNvCxnSpPr>
              <a:cxnSpLocks/>
            </p:cNvCxnSpPr>
            <p:nvPr/>
          </p:nvCxnSpPr>
          <p:spPr>
            <a:xfrm>
              <a:off x="216701"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Straight Connector 86">
              <a:extLst>
                <a:ext uri="{FF2B5EF4-FFF2-40B4-BE49-F238E27FC236}">
                  <a16:creationId xmlns:a16="http://schemas.microsoft.com/office/drawing/2014/main" id="{986DBBC7-5A74-4897-968F-3C7A51C45A69}"/>
                </a:ext>
              </a:extLst>
            </p:cNvPr>
            <p:cNvCxnSpPr>
              <a:cxnSpLocks/>
            </p:cNvCxnSpPr>
            <p:nvPr/>
          </p:nvCxnSpPr>
          <p:spPr>
            <a:xfrm>
              <a:off x="645872" y="2995736"/>
              <a:ext cx="0" cy="836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CDFC49C8-C6B1-4859-9972-A7B7473F0790}"/>
                </a:ext>
              </a:extLst>
            </p:cNvPr>
            <p:cNvCxnSpPr>
              <a:cxnSpLocks/>
            </p:cNvCxnSpPr>
            <p:nvPr/>
          </p:nvCxnSpPr>
          <p:spPr>
            <a:xfrm flipH="1">
              <a:off x="216701" y="3037556"/>
              <a:ext cx="429171"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1" name="Freeform: Shape 70">
            <a:extLst>
              <a:ext uri="{FF2B5EF4-FFF2-40B4-BE49-F238E27FC236}">
                <a16:creationId xmlns:a16="http://schemas.microsoft.com/office/drawing/2014/main" id="{16AB1D49-8647-4A44-95E7-B2623DE1F04F}"/>
              </a:ext>
            </a:extLst>
          </p:cNvPr>
          <p:cNvSpPr/>
          <p:nvPr/>
        </p:nvSpPr>
        <p:spPr>
          <a:xfrm>
            <a:off x="3815216" y="3095388"/>
            <a:ext cx="805723" cy="367019"/>
          </a:xfrm>
          <a:custGeom>
            <a:avLst/>
            <a:gdLst>
              <a:gd name="connsiteX0" fmla="*/ 0 w 1411794"/>
              <a:gd name="connsiteY0" fmla="*/ 643094 h 643094"/>
              <a:gd name="connsiteX1" fmla="*/ 236137 w 1411794"/>
              <a:gd name="connsiteY1" fmla="*/ 572756 h 643094"/>
              <a:gd name="connsiteX2" fmla="*/ 381838 w 1411794"/>
              <a:gd name="connsiteY2" fmla="*/ 547635 h 643094"/>
              <a:gd name="connsiteX3" fmla="*/ 557684 w 1411794"/>
              <a:gd name="connsiteY3" fmla="*/ 472272 h 643094"/>
              <a:gd name="connsiteX4" fmla="*/ 979715 w 1411794"/>
              <a:gd name="connsiteY4" fmla="*/ 236136 h 643094"/>
              <a:gd name="connsiteX5" fmla="*/ 1135464 w 1411794"/>
              <a:gd name="connsiteY5" fmla="*/ 140677 h 643094"/>
              <a:gd name="connsiteX6" fmla="*/ 1411794 w 1411794"/>
              <a:gd name="connsiteY6" fmla="*/ 0 h 643094"/>
              <a:gd name="connsiteX7" fmla="*/ 1411794 w 1411794"/>
              <a:gd name="connsiteY7" fmla="*/ 0 h 643094"/>
              <a:gd name="connsiteX8" fmla="*/ 1406769 w 1411794"/>
              <a:gd name="connsiteY8" fmla="*/ 0 h 6430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11794" h="643094">
                <a:moveTo>
                  <a:pt x="0" y="643094"/>
                </a:moveTo>
                <a:cubicBezTo>
                  <a:pt x="86248" y="615880"/>
                  <a:pt x="172497" y="588666"/>
                  <a:pt x="236137" y="572756"/>
                </a:cubicBezTo>
                <a:cubicBezTo>
                  <a:pt x="299777" y="556846"/>
                  <a:pt x="328247" y="564382"/>
                  <a:pt x="381838" y="547635"/>
                </a:cubicBezTo>
                <a:cubicBezTo>
                  <a:pt x="435429" y="530888"/>
                  <a:pt x="458038" y="524188"/>
                  <a:pt x="557684" y="472272"/>
                </a:cubicBezTo>
                <a:cubicBezTo>
                  <a:pt x="657330" y="420356"/>
                  <a:pt x="883418" y="291402"/>
                  <a:pt x="979715" y="236136"/>
                </a:cubicBezTo>
                <a:cubicBezTo>
                  <a:pt x="1076012" y="180870"/>
                  <a:pt x="1063451" y="180033"/>
                  <a:pt x="1135464" y="140677"/>
                </a:cubicBezTo>
                <a:cubicBezTo>
                  <a:pt x="1207477" y="101321"/>
                  <a:pt x="1411794" y="0"/>
                  <a:pt x="1411794" y="0"/>
                </a:cubicBezTo>
                <a:lnTo>
                  <a:pt x="1411794" y="0"/>
                </a:lnTo>
                <a:lnTo>
                  <a:pt x="1406769" y="0"/>
                </a:lnTo>
              </a:path>
            </a:pathLst>
          </a:custGeom>
          <a:noFill/>
          <a:ln w="1270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a:p>
        </p:txBody>
      </p:sp>
      <p:sp>
        <p:nvSpPr>
          <p:cNvPr id="74" name="Freeform: Shape 73">
            <a:extLst>
              <a:ext uri="{FF2B5EF4-FFF2-40B4-BE49-F238E27FC236}">
                <a16:creationId xmlns:a16="http://schemas.microsoft.com/office/drawing/2014/main" id="{62CFACA6-12E3-4991-9094-5BC876B97718}"/>
              </a:ext>
            </a:extLst>
          </p:cNvPr>
          <p:cNvSpPr/>
          <p:nvPr/>
        </p:nvSpPr>
        <p:spPr>
          <a:xfrm>
            <a:off x="4650314" y="3098255"/>
            <a:ext cx="805723" cy="367019"/>
          </a:xfrm>
          <a:custGeom>
            <a:avLst/>
            <a:gdLst>
              <a:gd name="connsiteX0" fmla="*/ 0 w 1411794"/>
              <a:gd name="connsiteY0" fmla="*/ 643094 h 643094"/>
              <a:gd name="connsiteX1" fmla="*/ 236137 w 1411794"/>
              <a:gd name="connsiteY1" fmla="*/ 572756 h 643094"/>
              <a:gd name="connsiteX2" fmla="*/ 381838 w 1411794"/>
              <a:gd name="connsiteY2" fmla="*/ 547635 h 643094"/>
              <a:gd name="connsiteX3" fmla="*/ 557684 w 1411794"/>
              <a:gd name="connsiteY3" fmla="*/ 472272 h 643094"/>
              <a:gd name="connsiteX4" fmla="*/ 979715 w 1411794"/>
              <a:gd name="connsiteY4" fmla="*/ 236136 h 643094"/>
              <a:gd name="connsiteX5" fmla="*/ 1135464 w 1411794"/>
              <a:gd name="connsiteY5" fmla="*/ 140677 h 643094"/>
              <a:gd name="connsiteX6" fmla="*/ 1411794 w 1411794"/>
              <a:gd name="connsiteY6" fmla="*/ 0 h 643094"/>
              <a:gd name="connsiteX7" fmla="*/ 1411794 w 1411794"/>
              <a:gd name="connsiteY7" fmla="*/ 0 h 643094"/>
              <a:gd name="connsiteX8" fmla="*/ 1406769 w 1411794"/>
              <a:gd name="connsiteY8" fmla="*/ 0 h 6430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11794" h="643094">
                <a:moveTo>
                  <a:pt x="0" y="643094"/>
                </a:moveTo>
                <a:cubicBezTo>
                  <a:pt x="86248" y="615880"/>
                  <a:pt x="172497" y="588666"/>
                  <a:pt x="236137" y="572756"/>
                </a:cubicBezTo>
                <a:cubicBezTo>
                  <a:pt x="299777" y="556846"/>
                  <a:pt x="328247" y="564382"/>
                  <a:pt x="381838" y="547635"/>
                </a:cubicBezTo>
                <a:cubicBezTo>
                  <a:pt x="435429" y="530888"/>
                  <a:pt x="458038" y="524188"/>
                  <a:pt x="557684" y="472272"/>
                </a:cubicBezTo>
                <a:cubicBezTo>
                  <a:pt x="657330" y="420356"/>
                  <a:pt x="883418" y="291402"/>
                  <a:pt x="979715" y="236136"/>
                </a:cubicBezTo>
                <a:cubicBezTo>
                  <a:pt x="1076012" y="180870"/>
                  <a:pt x="1063451" y="180033"/>
                  <a:pt x="1135464" y="140677"/>
                </a:cubicBezTo>
                <a:cubicBezTo>
                  <a:pt x="1207477" y="101321"/>
                  <a:pt x="1411794" y="0"/>
                  <a:pt x="1411794" y="0"/>
                </a:cubicBezTo>
                <a:lnTo>
                  <a:pt x="1411794" y="0"/>
                </a:lnTo>
                <a:lnTo>
                  <a:pt x="1406769" y="0"/>
                </a:lnTo>
              </a:path>
            </a:pathLst>
          </a:custGeom>
          <a:noFill/>
          <a:ln w="1270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a:p>
        </p:txBody>
      </p:sp>
      <p:sp>
        <p:nvSpPr>
          <p:cNvPr id="76" name="Freeform: Shape 75">
            <a:extLst>
              <a:ext uri="{FF2B5EF4-FFF2-40B4-BE49-F238E27FC236}">
                <a16:creationId xmlns:a16="http://schemas.microsoft.com/office/drawing/2014/main" id="{EC609CCC-1825-4A8C-9B45-12B04BAC740C}"/>
              </a:ext>
            </a:extLst>
          </p:cNvPr>
          <p:cNvSpPr/>
          <p:nvPr/>
        </p:nvSpPr>
        <p:spPr>
          <a:xfrm>
            <a:off x="5471581" y="3095388"/>
            <a:ext cx="805723" cy="367019"/>
          </a:xfrm>
          <a:custGeom>
            <a:avLst/>
            <a:gdLst>
              <a:gd name="connsiteX0" fmla="*/ 0 w 1411794"/>
              <a:gd name="connsiteY0" fmla="*/ 643094 h 643094"/>
              <a:gd name="connsiteX1" fmla="*/ 236137 w 1411794"/>
              <a:gd name="connsiteY1" fmla="*/ 572756 h 643094"/>
              <a:gd name="connsiteX2" fmla="*/ 381838 w 1411794"/>
              <a:gd name="connsiteY2" fmla="*/ 547635 h 643094"/>
              <a:gd name="connsiteX3" fmla="*/ 557684 w 1411794"/>
              <a:gd name="connsiteY3" fmla="*/ 472272 h 643094"/>
              <a:gd name="connsiteX4" fmla="*/ 979715 w 1411794"/>
              <a:gd name="connsiteY4" fmla="*/ 236136 h 643094"/>
              <a:gd name="connsiteX5" fmla="*/ 1135464 w 1411794"/>
              <a:gd name="connsiteY5" fmla="*/ 140677 h 643094"/>
              <a:gd name="connsiteX6" fmla="*/ 1411794 w 1411794"/>
              <a:gd name="connsiteY6" fmla="*/ 0 h 643094"/>
              <a:gd name="connsiteX7" fmla="*/ 1411794 w 1411794"/>
              <a:gd name="connsiteY7" fmla="*/ 0 h 643094"/>
              <a:gd name="connsiteX8" fmla="*/ 1406769 w 1411794"/>
              <a:gd name="connsiteY8" fmla="*/ 0 h 64309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411794" h="643094">
                <a:moveTo>
                  <a:pt x="0" y="643094"/>
                </a:moveTo>
                <a:cubicBezTo>
                  <a:pt x="86248" y="615880"/>
                  <a:pt x="172497" y="588666"/>
                  <a:pt x="236137" y="572756"/>
                </a:cubicBezTo>
                <a:cubicBezTo>
                  <a:pt x="299777" y="556846"/>
                  <a:pt x="328247" y="564382"/>
                  <a:pt x="381838" y="547635"/>
                </a:cubicBezTo>
                <a:cubicBezTo>
                  <a:pt x="435429" y="530888"/>
                  <a:pt x="458038" y="524188"/>
                  <a:pt x="557684" y="472272"/>
                </a:cubicBezTo>
                <a:cubicBezTo>
                  <a:pt x="657330" y="420356"/>
                  <a:pt x="883418" y="291402"/>
                  <a:pt x="979715" y="236136"/>
                </a:cubicBezTo>
                <a:cubicBezTo>
                  <a:pt x="1076012" y="180870"/>
                  <a:pt x="1063451" y="180033"/>
                  <a:pt x="1135464" y="140677"/>
                </a:cubicBezTo>
                <a:cubicBezTo>
                  <a:pt x="1207477" y="101321"/>
                  <a:pt x="1411794" y="0"/>
                  <a:pt x="1411794" y="0"/>
                </a:cubicBezTo>
                <a:lnTo>
                  <a:pt x="1411794" y="0"/>
                </a:lnTo>
                <a:lnTo>
                  <a:pt x="1406769" y="0"/>
                </a:lnTo>
              </a:path>
            </a:pathLst>
          </a:custGeom>
          <a:noFill/>
          <a:ln w="1270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a:p>
        </p:txBody>
      </p:sp>
      <p:sp>
        <p:nvSpPr>
          <p:cNvPr id="78" name="Freeform: Shape 77">
            <a:extLst>
              <a:ext uri="{FF2B5EF4-FFF2-40B4-BE49-F238E27FC236}">
                <a16:creationId xmlns:a16="http://schemas.microsoft.com/office/drawing/2014/main" id="{DE1E06A1-251B-49E5-950C-F2358178A00C}"/>
              </a:ext>
            </a:extLst>
          </p:cNvPr>
          <p:cNvSpPr/>
          <p:nvPr/>
        </p:nvSpPr>
        <p:spPr>
          <a:xfrm>
            <a:off x="3817102" y="2662283"/>
            <a:ext cx="797666" cy="275810"/>
          </a:xfrm>
          <a:custGeom>
            <a:avLst/>
            <a:gdLst>
              <a:gd name="connsiteX0" fmla="*/ 0 w 1397676"/>
              <a:gd name="connsiteY0" fmla="*/ 483276 h 483276"/>
              <a:gd name="connsiteX1" fmla="*/ 278145 w 1397676"/>
              <a:gd name="connsiteY1" fmla="*/ 399832 h 483276"/>
              <a:gd name="connsiteX2" fmla="*/ 671024 w 1397676"/>
              <a:gd name="connsiteY2" fmla="*/ 299005 h 483276"/>
              <a:gd name="connsiteX3" fmla="*/ 921354 w 1397676"/>
              <a:gd name="connsiteY3" fmla="*/ 215562 h 483276"/>
              <a:gd name="connsiteX4" fmla="*/ 1029135 w 1397676"/>
              <a:gd name="connsiteY4" fmla="*/ 170363 h 483276"/>
              <a:gd name="connsiteX5" fmla="*/ 1112578 w 1397676"/>
              <a:gd name="connsiteY5" fmla="*/ 152979 h 483276"/>
              <a:gd name="connsiteX6" fmla="*/ 1220359 w 1397676"/>
              <a:gd name="connsiteY6" fmla="*/ 79966 h 483276"/>
              <a:gd name="connsiteX7" fmla="*/ 1362908 w 1397676"/>
              <a:gd name="connsiteY7" fmla="*/ 38245 h 483276"/>
              <a:gd name="connsiteX8" fmla="*/ 1397676 w 1397676"/>
              <a:gd name="connsiteY8" fmla="*/ 0 h 4832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397676" h="483276">
                <a:moveTo>
                  <a:pt x="0" y="483276"/>
                </a:moveTo>
                <a:cubicBezTo>
                  <a:pt x="83154" y="456910"/>
                  <a:pt x="166308" y="430544"/>
                  <a:pt x="278145" y="399832"/>
                </a:cubicBezTo>
                <a:cubicBezTo>
                  <a:pt x="389982" y="369120"/>
                  <a:pt x="563823" y="329717"/>
                  <a:pt x="671024" y="299005"/>
                </a:cubicBezTo>
                <a:cubicBezTo>
                  <a:pt x="778225" y="268293"/>
                  <a:pt x="861669" y="237002"/>
                  <a:pt x="921354" y="215562"/>
                </a:cubicBezTo>
                <a:cubicBezTo>
                  <a:pt x="981039" y="194122"/>
                  <a:pt x="997264" y="180793"/>
                  <a:pt x="1029135" y="170363"/>
                </a:cubicBezTo>
                <a:cubicBezTo>
                  <a:pt x="1061006" y="159933"/>
                  <a:pt x="1080707" y="168045"/>
                  <a:pt x="1112578" y="152979"/>
                </a:cubicBezTo>
                <a:cubicBezTo>
                  <a:pt x="1144449" y="137913"/>
                  <a:pt x="1178637" y="99088"/>
                  <a:pt x="1220359" y="79966"/>
                </a:cubicBezTo>
                <a:cubicBezTo>
                  <a:pt x="1262081" y="60844"/>
                  <a:pt x="1333355" y="51573"/>
                  <a:pt x="1362908" y="38245"/>
                </a:cubicBezTo>
                <a:cubicBezTo>
                  <a:pt x="1392461" y="24917"/>
                  <a:pt x="1395068" y="12458"/>
                  <a:pt x="1397676" y="0"/>
                </a:cubicBezTo>
              </a:path>
            </a:pathLst>
          </a:custGeom>
          <a:noFill/>
          <a:ln w="1270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a:p>
        </p:txBody>
      </p:sp>
      <p:sp>
        <p:nvSpPr>
          <p:cNvPr id="79" name="Freeform: Shape 78">
            <a:extLst>
              <a:ext uri="{FF2B5EF4-FFF2-40B4-BE49-F238E27FC236}">
                <a16:creationId xmlns:a16="http://schemas.microsoft.com/office/drawing/2014/main" id="{D87FC0EA-D12E-481D-BDB0-EDDCEDCBD314}"/>
              </a:ext>
            </a:extLst>
          </p:cNvPr>
          <p:cNvSpPr/>
          <p:nvPr/>
        </p:nvSpPr>
        <p:spPr>
          <a:xfrm>
            <a:off x="4644142" y="2662283"/>
            <a:ext cx="797666" cy="275810"/>
          </a:xfrm>
          <a:custGeom>
            <a:avLst/>
            <a:gdLst>
              <a:gd name="connsiteX0" fmla="*/ 0 w 1397676"/>
              <a:gd name="connsiteY0" fmla="*/ 483276 h 483276"/>
              <a:gd name="connsiteX1" fmla="*/ 278145 w 1397676"/>
              <a:gd name="connsiteY1" fmla="*/ 399832 h 483276"/>
              <a:gd name="connsiteX2" fmla="*/ 671024 w 1397676"/>
              <a:gd name="connsiteY2" fmla="*/ 299005 h 483276"/>
              <a:gd name="connsiteX3" fmla="*/ 921354 w 1397676"/>
              <a:gd name="connsiteY3" fmla="*/ 215562 h 483276"/>
              <a:gd name="connsiteX4" fmla="*/ 1029135 w 1397676"/>
              <a:gd name="connsiteY4" fmla="*/ 170363 h 483276"/>
              <a:gd name="connsiteX5" fmla="*/ 1112578 w 1397676"/>
              <a:gd name="connsiteY5" fmla="*/ 152979 h 483276"/>
              <a:gd name="connsiteX6" fmla="*/ 1220359 w 1397676"/>
              <a:gd name="connsiteY6" fmla="*/ 79966 h 483276"/>
              <a:gd name="connsiteX7" fmla="*/ 1362908 w 1397676"/>
              <a:gd name="connsiteY7" fmla="*/ 38245 h 483276"/>
              <a:gd name="connsiteX8" fmla="*/ 1397676 w 1397676"/>
              <a:gd name="connsiteY8" fmla="*/ 0 h 4832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397676" h="483276">
                <a:moveTo>
                  <a:pt x="0" y="483276"/>
                </a:moveTo>
                <a:cubicBezTo>
                  <a:pt x="83154" y="456910"/>
                  <a:pt x="166308" y="430544"/>
                  <a:pt x="278145" y="399832"/>
                </a:cubicBezTo>
                <a:cubicBezTo>
                  <a:pt x="389982" y="369120"/>
                  <a:pt x="563823" y="329717"/>
                  <a:pt x="671024" y="299005"/>
                </a:cubicBezTo>
                <a:cubicBezTo>
                  <a:pt x="778225" y="268293"/>
                  <a:pt x="861669" y="237002"/>
                  <a:pt x="921354" y="215562"/>
                </a:cubicBezTo>
                <a:cubicBezTo>
                  <a:pt x="981039" y="194122"/>
                  <a:pt x="997264" y="180793"/>
                  <a:pt x="1029135" y="170363"/>
                </a:cubicBezTo>
                <a:cubicBezTo>
                  <a:pt x="1061006" y="159933"/>
                  <a:pt x="1080707" y="168045"/>
                  <a:pt x="1112578" y="152979"/>
                </a:cubicBezTo>
                <a:cubicBezTo>
                  <a:pt x="1144449" y="137913"/>
                  <a:pt x="1178637" y="99088"/>
                  <a:pt x="1220359" y="79966"/>
                </a:cubicBezTo>
                <a:cubicBezTo>
                  <a:pt x="1262081" y="60844"/>
                  <a:pt x="1333355" y="51573"/>
                  <a:pt x="1362908" y="38245"/>
                </a:cubicBezTo>
                <a:cubicBezTo>
                  <a:pt x="1392461" y="24917"/>
                  <a:pt x="1395068" y="12458"/>
                  <a:pt x="1397676" y="0"/>
                </a:cubicBezTo>
              </a:path>
            </a:pathLst>
          </a:custGeom>
          <a:noFill/>
          <a:ln w="1270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a:p>
        </p:txBody>
      </p:sp>
      <p:sp>
        <p:nvSpPr>
          <p:cNvPr id="80" name="Freeform: Shape 79">
            <a:extLst>
              <a:ext uri="{FF2B5EF4-FFF2-40B4-BE49-F238E27FC236}">
                <a16:creationId xmlns:a16="http://schemas.microsoft.com/office/drawing/2014/main" id="{B5CF3FC6-57B3-45E9-8DCA-57FAB3054A1E}"/>
              </a:ext>
            </a:extLst>
          </p:cNvPr>
          <p:cNvSpPr/>
          <p:nvPr/>
        </p:nvSpPr>
        <p:spPr>
          <a:xfrm>
            <a:off x="5479085" y="2662283"/>
            <a:ext cx="797666" cy="275810"/>
          </a:xfrm>
          <a:custGeom>
            <a:avLst/>
            <a:gdLst>
              <a:gd name="connsiteX0" fmla="*/ 0 w 1397676"/>
              <a:gd name="connsiteY0" fmla="*/ 483276 h 483276"/>
              <a:gd name="connsiteX1" fmla="*/ 278145 w 1397676"/>
              <a:gd name="connsiteY1" fmla="*/ 399832 h 483276"/>
              <a:gd name="connsiteX2" fmla="*/ 671024 w 1397676"/>
              <a:gd name="connsiteY2" fmla="*/ 299005 h 483276"/>
              <a:gd name="connsiteX3" fmla="*/ 921354 w 1397676"/>
              <a:gd name="connsiteY3" fmla="*/ 215562 h 483276"/>
              <a:gd name="connsiteX4" fmla="*/ 1029135 w 1397676"/>
              <a:gd name="connsiteY4" fmla="*/ 170363 h 483276"/>
              <a:gd name="connsiteX5" fmla="*/ 1112578 w 1397676"/>
              <a:gd name="connsiteY5" fmla="*/ 152979 h 483276"/>
              <a:gd name="connsiteX6" fmla="*/ 1220359 w 1397676"/>
              <a:gd name="connsiteY6" fmla="*/ 79966 h 483276"/>
              <a:gd name="connsiteX7" fmla="*/ 1362908 w 1397676"/>
              <a:gd name="connsiteY7" fmla="*/ 38245 h 483276"/>
              <a:gd name="connsiteX8" fmla="*/ 1397676 w 1397676"/>
              <a:gd name="connsiteY8" fmla="*/ 0 h 48327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1397676" h="483276">
                <a:moveTo>
                  <a:pt x="0" y="483276"/>
                </a:moveTo>
                <a:cubicBezTo>
                  <a:pt x="83154" y="456910"/>
                  <a:pt x="166308" y="430544"/>
                  <a:pt x="278145" y="399832"/>
                </a:cubicBezTo>
                <a:cubicBezTo>
                  <a:pt x="389982" y="369120"/>
                  <a:pt x="563823" y="329717"/>
                  <a:pt x="671024" y="299005"/>
                </a:cubicBezTo>
                <a:cubicBezTo>
                  <a:pt x="778225" y="268293"/>
                  <a:pt x="861669" y="237002"/>
                  <a:pt x="921354" y="215562"/>
                </a:cubicBezTo>
                <a:cubicBezTo>
                  <a:pt x="981039" y="194122"/>
                  <a:pt x="997264" y="180793"/>
                  <a:pt x="1029135" y="170363"/>
                </a:cubicBezTo>
                <a:cubicBezTo>
                  <a:pt x="1061006" y="159933"/>
                  <a:pt x="1080707" y="168045"/>
                  <a:pt x="1112578" y="152979"/>
                </a:cubicBezTo>
                <a:cubicBezTo>
                  <a:pt x="1144449" y="137913"/>
                  <a:pt x="1178637" y="99088"/>
                  <a:pt x="1220359" y="79966"/>
                </a:cubicBezTo>
                <a:cubicBezTo>
                  <a:pt x="1262081" y="60844"/>
                  <a:pt x="1333355" y="51573"/>
                  <a:pt x="1362908" y="38245"/>
                </a:cubicBezTo>
                <a:cubicBezTo>
                  <a:pt x="1392461" y="24917"/>
                  <a:pt x="1395068" y="12458"/>
                  <a:pt x="1397676" y="0"/>
                </a:cubicBezTo>
              </a:path>
            </a:pathLst>
          </a:custGeom>
          <a:noFill/>
          <a:ln w="12700">
            <a:solidFill>
              <a:schemeClr val="bg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a:p>
        </p:txBody>
      </p:sp>
      <p:pic>
        <p:nvPicPr>
          <p:cNvPr id="81" name="Picture 80">
            <a:extLst>
              <a:ext uri="{FF2B5EF4-FFF2-40B4-BE49-F238E27FC236}">
                <a16:creationId xmlns:a16="http://schemas.microsoft.com/office/drawing/2014/main" id="{C964EC62-EFDC-4C5F-A49C-EFC0B5059FDC}"/>
              </a:ext>
            </a:extLst>
          </p:cNvPr>
          <p:cNvPicPr>
            <a:picLocks noChangeAspect="1"/>
          </p:cNvPicPr>
          <p:nvPr/>
        </p:nvPicPr>
        <p:blipFill rotWithShape="1">
          <a:blip r:embed="rId17"/>
          <a:srcRect l="80148" t="82918"/>
          <a:stretch/>
        </p:blipFill>
        <p:spPr>
          <a:xfrm>
            <a:off x="5435585" y="3947617"/>
            <a:ext cx="851384" cy="464792"/>
          </a:xfrm>
          <a:prstGeom prst="rect">
            <a:avLst/>
          </a:prstGeom>
        </p:spPr>
      </p:pic>
      <p:sp>
        <p:nvSpPr>
          <p:cNvPr id="3" name="Rectangle 2">
            <a:extLst>
              <a:ext uri="{FF2B5EF4-FFF2-40B4-BE49-F238E27FC236}">
                <a16:creationId xmlns:a16="http://schemas.microsoft.com/office/drawing/2014/main" id="{EDB3C52A-BEEA-4587-8FDE-1345B9D34AA2}"/>
              </a:ext>
            </a:extLst>
          </p:cNvPr>
          <p:cNvSpPr/>
          <p:nvPr/>
        </p:nvSpPr>
        <p:spPr>
          <a:xfrm>
            <a:off x="5325171" y="4030783"/>
            <a:ext cx="151977" cy="18356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9"/>
          </a:p>
        </p:txBody>
      </p:sp>
      <p:sp>
        <p:nvSpPr>
          <p:cNvPr id="95" name="TextBox 94">
            <a:extLst>
              <a:ext uri="{FF2B5EF4-FFF2-40B4-BE49-F238E27FC236}">
                <a16:creationId xmlns:a16="http://schemas.microsoft.com/office/drawing/2014/main" id="{8D278A09-D6AE-4250-BAD1-41BC208D2A8D}"/>
              </a:ext>
            </a:extLst>
          </p:cNvPr>
          <p:cNvSpPr txBox="1"/>
          <p:nvPr/>
        </p:nvSpPr>
        <p:spPr>
          <a:xfrm>
            <a:off x="4743139" y="4066836"/>
            <a:ext cx="793807" cy="224229"/>
          </a:xfrm>
          <a:prstGeom prst="rect">
            <a:avLst/>
          </a:prstGeom>
          <a:noFill/>
        </p:spPr>
        <p:txBody>
          <a:bodyPr wrap="none" rtlCol="0">
            <a:spAutoFit/>
          </a:bodyPr>
          <a:lstStyle/>
          <a:p>
            <a:pPr algn="ctr"/>
            <a:r>
              <a:rPr lang="en-US" sz="857" b="1" dirty="0">
                <a:latin typeface="Arial" panose="020B0604020202020204" pitchFamily="34" charset="0"/>
                <a:cs typeface="Arial" panose="020B0604020202020204" pitchFamily="34" charset="0"/>
              </a:rPr>
              <a:t>1097.53 m/z</a:t>
            </a:r>
          </a:p>
        </p:txBody>
      </p:sp>
      <p:sp>
        <p:nvSpPr>
          <p:cNvPr id="96" name="TextBox 95">
            <a:extLst>
              <a:ext uri="{FF2B5EF4-FFF2-40B4-BE49-F238E27FC236}">
                <a16:creationId xmlns:a16="http://schemas.microsoft.com/office/drawing/2014/main" id="{D6C401CB-0987-406F-9DD3-6F4E59AB3BBB}"/>
              </a:ext>
            </a:extLst>
          </p:cNvPr>
          <p:cNvSpPr txBox="1"/>
          <p:nvPr/>
        </p:nvSpPr>
        <p:spPr>
          <a:xfrm>
            <a:off x="4768885" y="3931925"/>
            <a:ext cx="763349" cy="224229"/>
          </a:xfrm>
          <a:prstGeom prst="rect">
            <a:avLst/>
          </a:prstGeom>
          <a:noFill/>
        </p:spPr>
        <p:txBody>
          <a:bodyPr wrap="none" rtlCol="0">
            <a:spAutoFit/>
          </a:bodyPr>
          <a:lstStyle/>
          <a:p>
            <a:pPr algn="ctr"/>
            <a:r>
              <a:rPr lang="en-US" sz="857" b="1" dirty="0">
                <a:latin typeface="Arial" panose="020B0604020202020204" pitchFamily="34" charset="0"/>
                <a:cs typeface="Arial" panose="020B0604020202020204" pitchFamily="34" charset="0"/>
              </a:rPr>
              <a:t> 900.40 m/z</a:t>
            </a:r>
          </a:p>
        </p:txBody>
      </p:sp>
      <p:pic>
        <p:nvPicPr>
          <p:cNvPr id="13" name="Picture 12">
            <a:extLst>
              <a:ext uri="{FF2B5EF4-FFF2-40B4-BE49-F238E27FC236}">
                <a16:creationId xmlns:a16="http://schemas.microsoft.com/office/drawing/2014/main" id="{F64950B2-2A44-DB36-DDAE-00A6A249915C}"/>
              </a:ext>
            </a:extLst>
          </p:cNvPr>
          <p:cNvPicPr>
            <a:picLocks noChangeAspect="1"/>
          </p:cNvPicPr>
          <p:nvPr/>
        </p:nvPicPr>
        <p:blipFill rotWithShape="1">
          <a:blip r:embed="rId18"/>
          <a:srcRect t="10511"/>
          <a:stretch/>
        </p:blipFill>
        <p:spPr>
          <a:xfrm>
            <a:off x="5113066" y="1031494"/>
            <a:ext cx="1338656" cy="1244027"/>
          </a:xfrm>
          <a:prstGeom prst="rect">
            <a:avLst/>
          </a:prstGeom>
        </p:spPr>
      </p:pic>
      <p:pic>
        <p:nvPicPr>
          <p:cNvPr id="15" name="Picture 14">
            <a:extLst>
              <a:ext uri="{FF2B5EF4-FFF2-40B4-BE49-F238E27FC236}">
                <a16:creationId xmlns:a16="http://schemas.microsoft.com/office/drawing/2014/main" id="{48DE96E8-F6FA-FEB2-A2AD-067B86305F0C}"/>
              </a:ext>
            </a:extLst>
          </p:cNvPr>
          <p:cNvPicPr>
            <a:picLocks noChangeAspect="1"/>
          </p:cNvPicPr>
          <p:nvPr/>
        </p:nvPicPr>
        <p:blipFill rotWithShape="1">
          <a:blip r:embed="rId19"/>
          <a:srcRect t="12131"/>
          <a:stretch/>
        </p:blipFill>
        <p:spPr>
          <a:xfrm>
            <a:off x="2163199" y="1087072"/>
            <a:ext cx="1338655" cy="1181579"/>
          </a:xfrm>
          <a:prstGeom prst="rect">
            <a:avLst/>
          </a:prstGeom>
        </p:spPr>
      </p:pic>
      <p:sp>
        <p:nvSpPr>
          <p:cNvPr id="6" name="TextBox 5">
            <a:extLst>
              <a:ext uri="{FF2B5EF4-FFF2-40B4-BE49-F238E27FC236}">
                <a16:creationId xmlns:a16="http://schemas.microsoft.com/office/drawing/2014/main" id="{FE68CD77-2E17-4449-A113-D93BC3186C72}"/>
              </a:ext>
            </a:extLst>
          </p:cNvPr>
          <p:cNvSpPr txBox="1"/>
          <p:nvPr/>
        </p:nvSpPr>
        <p:spPr>
          <a:xfrm>
            <a:off x="323558" y="112542"/>
            <a:ext cx="3432516" cy="307777"/>
          </a:xfrm>
          <a:prstGeom prst="rect">
            <a:avLst/>
          </a:prstGeom>
          <a:noFill/>
        </p:spPr>
        <p:txBody>
          <a:bodyPr wrap="square">
            <a:spAutoFit/>
          </a:bodyPr>
          <a:lstStyle/>
          <a:p>
            <a:r>
              <a:rPr lang="en-US" sz="1400" b="1" dirty="0">
                <a:latin typeface="Arial" panose="020B0604020202020204" pitchFamily="34" charset="0"/>
                <a:ea typeface="Times New Roman" panose="02020603050405020304" pitchFamily="18" charset="0"/>
                <a:cs typeface="Arial" panose="020B0604020202020204" pitchFamily="34" charset="0"/>
              </a:rPr>
              <a:t>Supplemental Figure 4</a:t>
            </a:r>
            <a:endParaRPr lang="en-US" sz="1400" dirty="0"/>
          </a:p>
        </p:txBody>
      </p:sp>
    </p:spTree>
    <p:extLst>
      <p:ext uri="{BB962C8B-B14F-4D97-AF65-F5344CB8AC3E}">
        <p14:creationId xmlns:p14="http://schemas.microsoft.com/office/powerpoint/2010/main" val="10454913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59DBF6D-CE55-B425-467C-8AC186453A75}"/>
              </a:ext>
            </a:extLst>
          </p:cNvPr>
          <p:cNvSpPr>
            <a:spLocks noGrp="1"/>
          </p:cNvSpPr>
          <p:nvPr>
            <p:ph idx="1"/>
          </p:nvPr>
        </p:nvSpPr>
        <p:spPr>
          <a:xfrm>
            <a:off x="396395" y="577762"/>
            <a:ext cx="6104222" cy="3459665"/>
          </a:xfrm>
        </p:spPr>
        <p:txBody>
          <a:bodyPr>
            <a:noAutofit/>
          </a:bodyPr>
          <a:lstStyle/>
          <a:p>
            <a:pPr marL="0" indent="0" algn="just">
              <a:buNone/>
            </a:pPr>
            <a:r>
              <a:rPr lang="en-US" sz="1400" b="1" dirty="0">
                <a:latin typeface="Arial" panose="020B0604020202020204" pitchFamily="34" charset="0"/>
                <a:ea typeface="Times New Roman" panose="02020603050405020304" pitchFamily="18" charset="0"/>
                <a:cs typeface="Arial" panose="020B0604020202020204" pitchFamily="34" charset="0"/>
              </a:rPr>
              <a:t>Supplemental Figure 4: Additional Spatial Markers by MALDI-MSI of Skeletal Tissue. </a:t>
            </a:r>
            <a:r>
              <a:rPr lang="en-US" sz="1400" dirty="0">
                <a:latin typeface="Arial" panose="020B0604020202020204" pitchFamily="34" charset="0"/>
                <a:ea typeface="Times New Roman" panose="02020603050405020304" pitchFamily="18" charset="0"/>
                <a:cs typeface="Arial" panose="020B0604020202020204" pitchFamily="34" charset="0"/>
              </a:rPr>
              <a:t>Additional unique molecular features or peptides of skeletal marker proteins COL1A1, </a:t>
            </a:r>
            <a:r>
              <a:rPr lang="en-US" sz="1400" dirty="0">
                <a:latin typeface="Arial" panose="020B0604020202020204" pitchFamily="34" charset="0"/>
                <a:cs typeface="Arial" panose="020B0604020202020204" pitchFamily="34" charset="0"/>
              </a:rPr>
              <a:t>G</a:t>
            </a:r>
            <a:r>
              <a:rPr lang="en-US" sz="1400" baseline="30000" dirty="0">
                <a:latin typeface="Arial" panose="020B0604020202020204" pitchFamily="34" charset="0"/>
                <a:cs typeface="Arial" panose="020B0604020202020204" pitchFamily="34" charset="0"/>
              </a:rPr>
              <a:t>626</a:t>
            </a:r>
            <a:r>
              <a:rPr lang="en-US" sz="1400" dirty="0">
                <a:latin typeface="Arial" panose="020B0604020202020204" pitchFamily="34" charset="0"/>
                <a:cs typeface="Arial" panose="020B0604020202020204" pitchFamily="34" charset="0"/>
              </a:rPr>
              <a:t>PAGERGEQ</a:t>
            </a:r>
            <a:r>
              <a:rPr lang="en-US" sz="1400" baseline="30000" dirty="0">
                <a:latin typeface="Arial" panose="020B0604020202020204" pitchFamily="34" charset="0"/>
                <a:cs typeface="Arial" panose="020B0604020202020204" pitchFamily="34" charset="0"/>
              </a:rPr>
              <a:t>634</a:t>
            </a:r>
            <a:r>
              <a:rPr lang="en-US" sz="1400" dirty="0">
                <a:latin typeface="Arial" panose="020B0604020202020204" pitchFamily="34" charset="0"/>
                <a:ea typeface="Times New Roman" panose="02020603050405020304" pitchFamily="18" charset="0"/>
                <a:cs typeface="Arial" panose="020B0604020202020204" pitchFamily="34" charset="0"/>
              </a:rPr>
              <a:t> at m/z 900.40, for bone, and COL2A1, </a:t>
            </a:r>
            <a:r>
              <a:rPr lang="en-US" sz="1400" dirty="0">
                <a:solidFill>
                  <a:srgbClr val="000000"/>
                </a:solidFill>
                <a:latin typeface="Arial" panose="020B0604020202020204" pitchFamily="34" charset="0"/>
                <a:cs typeface="Arial" panose="020B0604020202020204" pitchFamily="34" charset="0"/>
              </a:rPr>
              <a:t>G</a:t>
            </a:r>
            <a:r>
              <a:rPr lang="en-US" sz="1400" baseline="30000" dirty="0">
                <a:solidFill>
                  <a:srgbClr val="000000"/>
                </a:solidFill>
                <a:latin typeface="Arial" panose="020B0604020202020204" pitchFamily="34" charset="0"/>
                <a:cs typeface="Arial" panose="020B0604020202020204" pitchFamily="34" charset="0"/>
              </a:rPr>
              <a:t>998</a:t>
            </a:r>
            <a:r>
              <a:rPr lang="en-US" sz="1400" dirty="0">
                <a:solidFill>
                  <a:srgbClr val="000000"/>
                </a:solidFill>
                <a:latin typeface="Arial" panose="020B0604020202020204" pitchFamily="34" charset="0"/>
                <a:cs typeface="Arial" panose="020B0604020202020204" pitchFamily="34" charset="0"/>
              </a:rPr>
              <a:t>PSGEPGKQGAP</a:t>
            </a:r>
            <a:r>
              <a:rPr lang="en-US" sz="1400" baseline="30000" dirty="0">
                <a:solidFill>
                  <a:srgbClr val="000000"/>
                </a:solidFill>
                <a:latin typeface="Arial" panose="020B0604020202020204" pitchFamily="34" charset="0"/>
                <a:cs typeface="Arial" panose="020B0604020202020204" pitchFamily="34" charset="0"/>
              </a:rPr>
              <a:t>1010</a:t>
            </a:r>
            <a:r>
              <a:rPr lang="en-US" sz="1400" dirty="0">
                <a:latin typeface="Arial" panose="020B0604020202020204" pitchFamily="34" charset="0"/>
                <a:ea typeface="Times New Roman" panose="02020603050405020304" pitchFamily="18" charset="0"/>
                <a:cs typeface="Arial" panose="020B0604020202020204" pitchFamily="34" charset="0"/>
              </a:rPr>
              <a:t>, for cartilage at m/z 1097.53 (A), were preferentially detected in the identified bone and cartilage areas demonstrating the agreement between the automatically generated regions and known skeletal tissues. *p &lt; 0.05 of average pixel intensity in bone (orange) vs cartilage (blue). (B) High resolution scanning (20-micron step) in a tissue region composed of the bone and cartilage junction showed the spatial delineation of tissue type and spatial distribution of peptides within trabecular bone. Interestingly this peptide of COL2A1 showed faint signal within trabecula but was most prominently contained with the cartilage region. High resolution images of the subchondral bone / cartilage junction for </a:t>
            </a:r>
            <a:r>
              <a:rPr lang="en-US" sz="1400" kern="0" dirty="0">
                <a:latin typeface="Arial" panose="020B0604020202020204" pitchFamily="34" charset="0"/>
                <a:ea typeface="Times New Roman" panose="02020603050405020304" pitchFamily="18" charset="0"/>
              </a:rPr>
              <a:t>unidentified peptide features</a:t>
            </a:r>
            <a:r>
              <a:rPr lang="en-US" sz="1400" dirty="0">
                <a:latin typeface="Arial" panose="020B0604020202020204" pitchFamily="34" charset="0"/>
                <a:ea typeface="Times New Roman" panose="02020603050405020304" pitchFamily="18" charset="0"/>
                <a:cs typeface="Arial" panose="020B0604020202020204" pitchFamily="34" charset="0"/>
              </a:rPr>
              <a:t> at (C) m/z 1943.91, (D) m/z 1406.71, and (E) m/z </a:t>
            </a:r>
            <a:r>
              <a:rPr lang="en-US" sz="1400">
                <a:latin typeface="Arial" panose="020B0604020202020204" pitchFamily="34" charset="0"/>
                <a:ea typeface="Times New Roman" panose="02020603050405020304" pitchFamily="18" charset="0"/>
                <a:cs typeface="Arial" panose="020B0604020202020204" pitchFamily="34" charset="0"/>
              </a:rPr>
              <a:t>1242.58 showed </a:t>
            </a:r>
            <a:r>
              <a:rPr lang="en-US" sz="1400" dirty="0">
                <a:latin typeface="Arial" panose="020B0604020202020204" pitchFamily="34" charset="0"/>
                <a:ea typeface="Times New Roman" panose="02020603050405020304" pitchFamily="18" charset="0"/>
                <a:cs typeface="Arial" panose="020B0604020202020204" pitchFamily="34" charset="0"/>
              </a:rPr>
              <a:t>additional unique spatial distributions for different molecular features and ‘hot spots’ within the subchondral trabecular bone and with low signal from the cartilage region.</a:t>
            </a:r>
          </a:p>
        </p:txBody>
      </p:sp>
    </p:spTree>
    <p:extLst>
      <p:ext uri="{BB962C8B-B14F-4D97-AF65-F5344CB8AC3E}">
        <p14:creationId xmlns:p14="http://schemas.microsoft.com/office/powerpoint/2010/main" val="235660701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7</TotalTime>
  <Words>329</Words>
  <Application>Microsoft Macintosh PowerPoint</Application>
  <PresentationFormat>Letter Paper (8.5x11 in)</PresentationFormat>
  <Paragraphs>31</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ptos</vt:lpstr>
      <vt:lpstr>Aptos Display</vt:lpstr>
      <vt:lpstr>Arial</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harlie Schurman</dc:creator>
  <cp:lastModifiedBy>Birgit Schilling</cp:lastModifiedBy>
  <cp:revision>14</cp:revision>
  <dcterms:created xsi:type="dcterms:W3CDTF">2024-10-28T17:59:57Z</dcterms:created>
  <dcterms:modified xsi:type="dcterms:W3CDTF">2025-01-22T03:27:51Z</dcterms:modified>
</cp:coreProperties>
</file>